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charts/chart16.xml" ContentType="application/vnd.openxmlformats-officedocument.drawingml.char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10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s-MX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9822" autoAdjust="0"/>
  </p:normalViewPr>
  <p:slideViewPr>
    <p:cSldViewPr>
      <p:cViewPr varScale="1">
        <p:scale>
          <a:sx n="109" d="100"/>
          <a:sy n="109" d="100"/>
        </p:scale>
        <p:origin x="-100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6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ropbox\Articulo\CineticasEnero62012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ropbox\Articulo\CineticasEnero62012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ropbox\Articulo\CineticasEnero62012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ropbox\Articulo\CineticasEnero62012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ropbox\Articulo\CineticasEnero62012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ropbox\Articulo\CineticasEnero62012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ropbox\Articulo\CineticasEnero62012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ropbox\Articulo\CineticasEnero6201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ropbox\Articulo\CineticasEnero6201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ropbox\Articulo\CineticasEnero6201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ropbox\Articulo\CineticasEnero62012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ropbox\Articulo\CineticasEnero62012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ropbox\Articulo\CineticasEnero62012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ropbox\Articulo\CineticasEnero62012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ropbox\Articulo\CineticasEnero62012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fugre\Dropbox\Articulo\CineticasEnero6201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scatterChart>
        <c:scatterStyle val="smoothMarker"/>
        <c:ser>
          <c:idx val="0"/>
          <c:order val="0"/>
          <c:tx>
            <c:strRef>
              <c:f>'W31'!$N$108</c:f>
              <c:strCache>
                <c:ptCount val="1"/>
                <c:pt idx="0">
                  <c:v>Velocidad de crecimiento</c:v>
                </c:pt>
              </c:strCache>
            </c:strRef>
          </c:tx>
          <c:spPr>
            <a:ln w="12700"/>
          </c:spPr>
          <c:marker>
            <c:symbol val="circle"/>
            <c:size val="3"/>
          </c:marker>
          <c:errBars>
            <c:errDir val="y"/>
            <c:errBarType val="both"/>
            <c:errValType val="cust"/>
            <c:plus>
              <c:numRef>
                <c:f>'W31'!$O$109:$O$117</c:f>
                <c:numCache>
                  <c:formatCode>General</c:formatCode>
                  <c:ptCount val="9"/>
                  <c:pt idx="0">
                    <c:v>1.1136931803688128E-3</c:v>
                  </c:pt>
                  <c:pt idx="1">
                    <c:v>8.2731493398826052E-3</c:v>
                  </c:pt>
                  <c:pt idx="2">
                    <c:v>1.2091525958289965E-2</c:v>
                  </c:pt>
                  <c:pt idx="3">
                    <c:v>1.1136931803688079E-2</c:v>
                  </c:pt>
                  <c:pt idx="4">
                    <c:v>3.1819805153395077E-3</c:v>
                  </c:pt>
                  <c:pt idx="5">
                    <c:v>9.4663920331349086E-2</c:v>
                  </c:pt>
                  <c:pt idx="6">
                    <c:v>7.684482944544796E-2</c:v>
                  </c:pt>
                  <c:pt idx="7">
                    <c:v>6.7617085950963704E-2</c:v>
                  </c:pt>
                  <c:pt idx="8">
                    <c:v>2.5774042174249747E-2</c:v>
                  </c:pt>
                </c:numCache>
              </c:numRef>
            </c:plus>
            <c:minus>
              <c:numRef>
                <c:f>'W31'!$O$109:$O$117</c:f>
                <c:numCache>
                  <c:formatCode>General</c:formatCode>
                  <c:ptCount val="9"/>
                  <c:pt idx="0">
                    <c:v>1.1136931803688128E-3</c:v>
                  </c:pt>
                  <c:pt idx="1">
                    <c:v>8.2731493398826052E-3</c:v>
                  </c:pt>
                  <c:pt idx="2">
                    <c:v>1.2091525958289965E-2</c:v>
                  </c:pt>
                  <c:pt idx="3">
                    <c:v>1.1136931803688079E-2</c:v>
                  </c:pt>
                  <c:pt idx="4">
                    <c:v>3.1819805153395077E-3</c:v>
                  </c:pt>
                  <c:pt idx="5">
                    <c:v>9.4663920331349086E-2</c:v>
                  </c:pt>
                  <c:pt idx="6">
                    <c:v>7.684482944544796E-2</c:v>
                  </c:pt>
                  <c:pt idx="7">
                    <c:v>6.7617085950963704E-2</c:v>
                  </c:pt>
                  <c:pt idx="8">
                    <c:v>2.5774042174249747E-2</c:v>
                  </c:pt>
                </c:numCache>
              </c:numRef>
            </c:minus>
          </c:errBars>
          <c:xVal>
            <c:numRef>
              <c:f>'W31'!$J$109:$J$117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</c:numCache>
            </c:numRef>
          </c:xVal>
          <c:yVal>
            <c:numRef>
              <c:f>'W31'!$N$109:$N$117</c:f>
              <c:numCache>
                <c:formatCode>General</c:formatCode>
                <c:ptCount val="9"/>
                <c:pt idx="0">
                  <c:v>4.542750000000001E-2</c:v>
                </c:pt>
                <c:pt idx="1">
                  <c:v>8.3835000000000062E-2</c:v>
                </c:pt>
                <c:pt idx="2">
                  <c:v>0.15975000000000006</c:v>
                </c:pt>
                <c:pt idx="3">
                  <c:v>0.31936500000000012</c:v>
                </c:pt>
                <c:pt idx="4">
                  <c:v>0.72607500000000025</c:v>
                </c:pt>
                <c:pt idx="5">
                  <c:v>1.1165625000000001</c:v>
                </c:pt>
                <c:pt idx="6">
                  <c:v>1.1633625000000001</c:v>
                </c:pt>
                <c:pt idx="7">
                  <c:v>1.2736125</c:v>
                </c:pt>
                <c:pt idx="8">
                  <c:v>1.3491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'W31'!$AB$108</c:f>
              <c:strCache>
                <c:ptCount val="1"/>
                <c:pt idx="0">
                  <c:v>Acetato</c:v>
                </c:pt>
              </c:strCache>
            </c:strRef>
          </c:tx>
          <c:spPr>
            <a:ln w="12700"/>
          </c:spPr>
          <c:marker>
            <c:symbol val="triangle"/>
            <c:size val="3"/>
          </c:marker>
          <c:errBars>
            <c:errDir val="y"/>
            <c:errBarType val="both"/>
            <c:errValType val="cust"/>
            <c:plus>
              <c:numRef>
                <c:f>'W31'!$AC$109:$AC$117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1.1547005383792523E-2</c:v>
                  </c:pt>
                  <c:pt idx="2">
                    <c:v>2.8867513459481329E-3</c:v>
                  </c:pt>
                  <c:pt idx="3">
                    <c:v>3.8223029707232833E-2</c:v>
                  </c:pt>
                  <c:pt idx="4">
                    <c:v>4.936598018879005E-2</c:v>
                  </c:pt>
                  <c:pt idx="5">
                    <c:v>9.0737717258774428E-3</c:v>
                  </c:pt>
                  <c:pt idx="6">
                    <c:v>5.7143095237599306E-2</c:v>
                  </c:pt>
                  <c:pt idx="7">
                    <c:v>5.0921508225896049E-2</c:v>
                  </c:pt>
                  <c:pt idx="8">
                    <c:v>0</c:v>
                  </c:pt>
                </c:numCache>
              </c:numRef>
            </c:plus>
            <c:minus>
              <c:numRef>
                <c:f>'W31'!$AC$109:$AC$117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1.1547005383792523E-2</c:v>
                  </c:pt>
                  <c:pt idx="2">
                    <c:v>2.8867513459481329E-3</c:v>
                  </c:pt>
                  <c:pt idx="3">
                    <c:v>3.8223029707232833E-2</c:v>
                  </c:pt>
                  <c:pt idx="4">
                    <c:v>4.936598018879005E-2</c:v>
                  </c:pt>
                  <c:pt idx="5">
                    <c:v>9.0737717258774428E-3</c:v>
                  </c:pt>
                  <c:pt idx="6">
                    <c:v>5.7143095237599306E-2</c:v>
                  </c:pt>
                  <c:pt idx="7">
                    <c:v>5.0921508225896049E-2</c:v>
                  </c:pt>
                  <c:pt idx="8">
                    <c:v>0</c:v>
                  </c:pt>
                </c:numCache>
              </c:numRef>
            </c:minus>
          </c:errBars>
          <c:xVal>
            <c:numRef>
              <c:f>'W31'!$X$109:$X$117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</c:numCache>
            </c:numRef>
          </c:xVal>
          <c:yVal>
            <c:numRef>
              <c:f>'W31'!$AB$109:$AB$117</c:f>
              <c:numCache>
                <c:formatCode>General</c:formatCode>
                <c:ptCount val="9"/>
                <c:pt idx="0">
                  <c:v>0</c:v>
                </c:pt>
                <c:pt idx="1">
                  <c:v>6.6666666666666697E-3</c:v>
                </c:pt>
                <c:pt idx="2">
                  <c:v>5.2666666666666702E-2</c:v>
                </c:pt>
                <c:pt idx="3">
                  <c:v>0.15400000000000005</c:v>
                </c:pt>
                <c:pt idx="4">
                  <c:v>0.26</c:v>
                </c:pt>
                <c:pt idx="5">
                  <c:v>0.28233333333333333</c:v>
                </c:pt>
                <c:pt idx="6">
                  <c:v>0.20633333333333342</c:v>
                </c:pt>
                <c:pt idx="7">
                  <c:v>6.200000000000002E-2</c:v>
                </c:pt>
                <c:pt idx="8">
                  <c:v>0</c:v>
                </c:pt>
              </c:numCache>
            </c:numRef>
          </c:yVal>
          <c:smooth val="1"/>
        </c:ser>
        <c:axId val="40678144"/>
        <c:axId val="40680064"/>
      </c:scatterChart>
      <c:scatterChart>
        <c:scatterStyle val="smoothMarker"/>
        <c:ser>
          <c:idx val="1"/>
          <c:order val="1"/>
          <c:tx>
            <c:v>Glucosa</c:v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'W31'!$V$109:$V$117</c:f>
                <c:numCache>
                  <c:formatCode>General</c:formatCode>
                  <c:ptCount val="9"/>
                  <c:pt idx="0">
                    <c:v>0.19035843383820278</c:v>
                  </c:pt>
                  <c:pt idx="1">
                    <c:v>4.3405068828421399E-2</c:v>
                  </c:pt>
                  <c:pt idx="2">
                    <c:v>5.3028294334251588E-2</c:v>
                  </c:pt>
                  <c:pt idx="3">
                    <c:v>7.7074639149333726E-2</c:v>
                  </c:pt>
                  <c:pt idx="4">
                    <c:v>0.12079045216130843</c:v>
                  </c:pt>
                  <c:pt idx="5">
                    <c:v>7.7674534651540506E-2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'W31'!$V$109:$V$117</c:f>
                <c:numCache>
                  <c:formatCode>General</c:formatCode>
                  <c:ptCount val="9"/>
                  <c:pt idx="0">
                    <c:v>0.19035843383820278</c:v>
                  </c:pt>
                  <c:pt idx="1">
                    <c:v>4.3405068828421399E-2</c:v>
                  </c:pt>
                  <c:pt idx="2">
                    <c:v>5.3028294334251588E-2</c:v>
                  </c:pt>
                  <c:pt idx="3">
                    <c:v>7.7074639149333726E-2</c:v>
                  </c:pt>
                  <c:pt idx="4">
                    <c:v>0.12079045216130843</c:v>
                  </c:pt>
                  <c:pt idx="5">
                    <c:v>7.7674534651540506E-2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</c:errBars>
          <c:xVal>
            <c:numRef>
              <c:f>'W31'!$Q$109:$Q$117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</c:numCache>
            </c:numRef>
          </c:xVal>
          <c:yVal>
            <c:numRef>
              <c:f>'W31'!$U$109:$U$117</c:f>
              <c:numCache>
                <c:formatCode>General</c:formatCode>
                <c:ptCount val="9"/>
                <c:pt idx="0">
                  <c:v>2.5776666666666666</c:v>
                </c:pt>
                <c:pt idx="1">
                  <c:v>2.4559999999999991</c:v>
                </c:pt>
                <c:pt idx="2">
                  <c:v>2.3149999999999991</c:v>
                </c:pt>
                <c:pt idx="3">
                  <c:v>1.7614999999999998</c:v>
                </c:pt>
                <c:pt idx="4">
                  <c:v>1.2353333333333334</c:v>
                </c:pt>
                <c:pt idx="5">
                  <c:v>0.40266666666666684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yVal>
          <c:smooth val="1"/>
        </c:ser>
        <c:axId val="40688256"/>
        <c:axId val="40686336"/>
      </c:scatterChart>
      <c:valAx>
        <c:axId val="40678144"/>
        <c:scaling>
          <c:orientation val="minMax"/>
          <c:max val="8"/>
        </c:scaling>
        <c:axPos val="b"/>
        <c:title>
          <c:tx>
            <c:rich>
              <a:bodyPr/>
              <a:lstStyle/>
              <a:p>
                <a:pPr>
                  <a:defRPr sz="700"/>
                </a:pPr>
                <a:r>
                  <a:rPr lang="en-US" sz="700" dirty="0"/>
                  <a:t>Time (h)</a:t>
                </a:r>
              </a:p>
            </c:rich>
          </c:tx>
          <c:layout>
            <c:manualLayout>
              <c:xMode val="edge"/>
              <c:yMode val="edge"/>
              <c:x val="0.43402870870786148"/>
              <c:y val="0.8160820456425778"/>
            </c:manualLayout>
          </c:layout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0680064"/>
        <c:crosses val="autoZero"/>
        <c:crossBetween val="midCat"/>
        <c:majorUnit val="2"/>
      </c:valAx>
      <c:valAx>
        <c:axId val="40680064"/>
        <c:scaling>
          <c:orientation val="minMax"/>
          <c:min val="0"/>
        </c:scaling>
        <c:axPos val="l"/>
        <c:majorGridlines>
          <c:spPr>
            <a:ln w="0"/>
          </c:spPr>
        </c:majorGridlines>
        <c:title>
          <c:tx>
            <c:rich>
              <a:bodyPr rot="-5400000" vert="horz"/>
              <a:lstStyle/>
              <a:p>
                <a:pPr>
                  <a:defRPr sz="700"/>
                </a:pPr>
                <a:r>
                  <a:rPr lang="en-US" sz="700" dirty="0"/>
                  <a:t>Biomass, Acetate</a:t>
                </a:r>
              </a:p>
              <a:p>
                <a:pPr>
                  <a:defRPr sz="700"/>
                </a:pPr>
                <a:r>
                  <a:rPr lang="en-US" sz="700" dirty="0"/>
                  <a:t> Conc., g/L</a:t>
                </a: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0678144"/>
        <c:crosses val="autoZero"/>
        <c:crossBetween val="midCat"/>
      </c:valAx>
      <c:valAx>
        <c:axId val="40686336"/>
        <c:scaling>
          <c:orientation val="minMax"/>
          <c:max val="3"/>
          <c:min val="0"/>
        </c:scaling>
        <c:axPos val="r"/>
        <c:title>
          <c:tx>
            <c:rich>
              <a:bodyPr rot="-5400000" vert="horz"/>
              <a:lstStyle/>
              <a:p>
                <a:pPr>
                  <a:defRPr sz="700"/>
                </a:pPr>
                <a:r>
                  <a:rPr lang="en-US" sz="700" dirty="0"/>
                  <a:t>Glucose Conc.,  g/L</a:t>
                </a: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0688256"/>
        <c:crosses val="max"/>
        <c:crossBetween val="midCat"/>
      </c:valAx>
      <c:valAx>
        <c:axId val="40688256"/>
        <c:scaling>
          <c:orientation val="minMax"/>
        </c:scaling>
        <c:delete val="1"/>
        <c:axPos val="b"/>
        <c:numFmt formatCode="General" sourceLinked="1"/>
        <c:tickLblPos val="none"/>
        <c:crossAx val="40686336"/>
        <c:crosses val="autoZero"/>
        <c:crossBetween val="midCat"/>
      </c:valAx>
    </c:plotArea>
    <c:plotVisOnly val="1"/>
    <c:dispBlanksAs val="gap"/>
  </c:chart>
  <c:spPr>
    <a:ln>
      <a:noFill/>
    </a:ln>
  </c:spPr>
  <c:externalData r:id="rId1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scatterChart>
        <c:scatterStyle val="smoothMarker"/>
        <c:ser>
          <c:idx val="0"/>
          <c:order val="0"/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plus>
              <c:numRef>
                <c:f>'301ptsGglk'!$N$107:$N$113</c:f>
                <c:numCache>
                  <c:formatCode>General</c:formatCode>
                  <c:ptCount val="7"/>
                  <c:pt idx="0">
                    <c:v>1.9410081143570721E-3</c:v>
                  </c:pt>
                  <c:pt idx="1">
                    <c:v>1.1805147711909417E-2</c:v>
                  </c:pt>
                  <c:pt idx="2">
                    <c:v>1.7659991860134002E-2</c:v>
                  </c:pt>
                  <c:pt idx="3">
                    <c:v>8.9890949558339872E-2</c:v>
                  </c:pt>
                  <c:pt idx="4">
                    <c:v>0.1543260549939639</c:v>
                  </c:pt>
                  <c:pt idx="5">
                    <c:v>0.18328207768355401</c:v>
                  </c:pt>
                  <c:pt idx="6">
                    <c:v>0</c:v>
                  </c:pt>
                </c:numCache>
              </c:numRef>
            </c:plus>
            <c:minus>
              <c:numRef>
                <c:f>'301ptsGglk'!$N$107:$N$113</c:f>
                <c:numCache>
                  <c:formatCode>General</c:formatCode>
                  <c:ptCount val="7"/>
                  <c:pt idx="0">
                    <c:v>1.9410081143570721E-3</c:v>
                  </c:pt>
                  <c:pt idx="1">
                    <c:v>1.1805147711909417E-2</c:v>
                  </c:pt>
                  <c:pt idx="2">
                    <c:v>1.7659991860134002E-2</c:v>
                  </c:pt>
                  <c:pt idx="3">
                    <c:v>8.9890949558339872E-2</c:v>
                  </c:pt>
                  <c:pt idx="4">
                    <c:v>0.1543260549939639</c:v>
                  </c:pt>
                  <c:pt idx="5">
                    <c:v>0.18328207768355401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'301ptsGglk'!$J$107:$J$113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</c:numCache>
            </c:numRef>
          </c:xVal>
          <c:yVal>
            <c:numRef>
              <c:f>'301ptsGglk'!$M$107:$M$113</c:f>
              <c:numCache>
                <c:formatCode>General</c:formatCode>
                <c:ptCount val="7"/>
                <c:pt idx="0">
                  <c:v>3.9397500000000002E-2</c:v>
                </c:pt>
                <c:pt idx="1">
                  <c:v>0.11954250000000002</c:v>
                </c:pt>
                <c:pt idx="2">
                  <c:v>0.34548750000000011</c:v>
                </c:pt>
                <c:pt idx="3">
                  <c:v>0.68883749999999999</c:v>
                </c:pt>
                <c:pt idx="4">
                  <c:v>1.1524500000000004</c:v>
                </c:pt>
                <c:pt idx="5">
                  <c:v>1.153575</c:v>
                </c:pt>
                <c:pt idx="6">
                  <c:v>0.98774999999999991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'301ptsGglk'!$Y$106</c:f>
              <c:strCache>
                <c:ptCount val="1"/>
                <c:pt idx="0">
                  <c:v>acetato</c:v>
                </c:pt>
              </c:strCache>
            </c:strRef>
          </c:tx>
          <c:spPr>
            <a:ln w="12700"/>
          </c:spPr>
          <c:marker>
            <c:symbol val="triangle"/>
            <c:size val="3"/>
          </c:marker>
          <c:errBars>
            <c:errDir val="y"/>
            <c:errBarType val="both"/>
            <c:errValType val="cust"/>
            <c:plus>
              <c:numRef>
                <c:f>'301ptsGglk'!$Z$107:$Z$11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3.5355339059327403E-3</c:v>
                  </c:pt>
                  <c:pt idx="2">
                    <c:v>2.8284271247461914E-3</c:v>
                  </c:pt>
                  <c:pt idx="3">
                    <c:v>1.1313708498984673E-2</c:v>
                  </c:pt>
                  <c:pt idx="4">
                    <c:v>4.1719300090006316E-2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'301ptsGglk'!$Z$107:$Z$11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3.5355339059327403E-3</c:v>
                  </c:pt>
                  <c:pt idx="2">
                    <c:v>2.8284271247461914E-3</c:v>
                  </c:pt>
                  <c:pt idx="3">
                    <c:v>1.1313708498984673E-2</c:v>
                  </c:pt>
                  <c:pt idx="4">
                    <c:v>4.1719300090006316E-2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'301ptsGglk'!$V$107:$V$113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</c:numCache>
            </c:numRef>
          </c:xVal>
          <c:yVal>
            <c:numRef>
              <c:f>'301ptsGglk'!$Y$107:$Y$113</c:f>
              <c:numCache>
                <c:formatCode>General</c:formatCode>
                <c:ptCount val="7"/>
                <c:pt idx="0">
                  <c:v>0</c:v>
                </c:pt>
                <c:pt idx="1">
                  <c:v>2.0500000000000001E-2</c:v>
                </c:pt>
                <c:pt idx="2">
                  <c:v>1.8000000000000009E-2</c:v>
                </c:pt>
                <c:pt idx="3">
                  <c:v>7.3000000000000009E-2</c:v>
                </c:pt>
                <c:pt idx="4">
                  <c:v>0.14250000000000004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1"/>
        </c:ser>
        <c:axId val="43586688"/>
        <c:axId val="43588608"/>
      </c:scatterChart>
      <c:scatterChart>
        <c:scatterStyle val="smoothMarker"/>
        <c:ser>
          <c:idx val="1"/>
          <c:order val="1"/>
          <c:tx>
            <c:strRef>
              <c:f>'301ptsGglk'!$R$106</c:f>
              <c:strCache>
                <c:ptCount val="1"/>
                <c:pt idx="0">
                  <c:v>Glucosa 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'301ptsGglk'!$T$107:$T$113</c:f>
                <c:numCache>
                  <c:formatCode>General</c:formatCode>
                  <c:ptCount val="7"/>
                  <c:pt idx="0">
                    <c:v>0.15839191898578647</c:v>
                  </c:pt>
                  <c:pt idx="1">
                    <c:v>0.22980970388562783</c:v>
                  </c:pt>
                  <c:pt idx="2">
                    <c:v>0.1187939392393398</c:v>
                  </c:pt>
                  <c:pt idx="3">
                    <c:v>5.1618795026618113E-2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'301ptsGglk'!$T$107:$T$113</c:f>
                <c:numCache>
                  <c:formatCode>General</c:formatCode>
                  <c:ptCount val="7"/>
                  <c:pt idx="0">
                    <c:v>0.15839191898578647</c:v>
                  </c:pt>
                  <c:pt idx="1">
                    <c:v>0.22980970388562783</c:v>
                  </c:pt>
                  <c:pt idx="2">
                    <c:v>0.1187939392393398</c:v>
                  </c:pt>
                  <c:pt idx="3">
                    <c:v>5.1618795026618113E-2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'301ptsGglk'!$P$107:$P$113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</c:numCache>
            </c:numRef>
          </c:xVal>
          <c:yVal>
            <c:numRef>
              <c:f>'301ptsGglk'!$S$107:$S$113</c:f>
              <c:numCache>
                <c:formatCode>General</c:formatCode>
                <c:ptCount val="7"/>
                <c:pt idx="0">
                  <c:v>2.6070000000000002</c:v>
                </c:pt>
                <c:pt idx="1">
                  <c:v>2.410499999999999</c:v>
                </c:pt>
                <c:pt idx="2">
                  <c:v>2.0629999999999997</c:v>
                </c:pt>
                <c:pt idx="3">
                  <c:v>1.2044999999999995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1"/>
        </c:ser>
        <c:axId val="43600896"/>
        <c:axId val="43598976"/>
      </c:scatterChart>
      <c:valAx>
        <c:axId val="43586688"/>
        <c:scaling>
          <c:orientation val="minMax"/>
          <c:max val="12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Time (h)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3588608"/>
        <c:crosses val="autoZero"/>
        <c:crossBetween val="midCat"/>
        <c:majorUnit val="2"/>
      </c:valAx>
      <c:valAx>
        <c:axId val="43588608"/>
        <c:scaling>
          <c:orientation val="minMax"/>
          <c:min val="0"/>
        </c:scaling>
        <c:axPos val="l"/>
        <c:majorGridlines>
          <c:spPr>
            <a:ln w="0"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Biomass, Acetate</a:t>
                </a:r>
                <a:endParaRPr lang="es-MX" sz="700" dirty="0" smtClean="0">
                  <a:effectLst/>
                </a:endParaRPr>
              </a:p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3586688"/>
        <c:crosses val="autoZero"/>
        <c:crossBetween val="midCat"/>
      </c:valAx>
      <c:valAx>
        <c:axId val="43598976"/>
        <c:scaling>
          <c:orientation val="minMax"/>
          <c:min val="0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3600896"/>
        <c:crosses val="max"/>
        <c:crossBetween val="midCat"/>
      </c:valAx>
      <c:valAx>
        <c:axId val="43600896"/>
        <c:scaling>
          <c:orientation val="minMax"/>
        </c:scaling>
        <c:delete val="1"/>
        <c:axPos val="b"/>
        <c:numFmt formatCode="General" sourceLinked="1"/>
        <c:tickLblPos val="none"/>
        <c:crossAx val="43598976"/>
        <c:crosses val="autoZero"/>
        <c:crossBetween val="midCat"/>
      </c:valAx>
    </c:plotArea>
    <c:plotVisOnly val="1"/>
    <c:dispBlanksAs val="gap"/>
  </c:chart>
  <c:externalData r:id="rId1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scatterChart>
        <c:scatterStyle val="smoothMarker"/>
        <c:ser>
          <c:idx val="0"/>
          <c:order val="0"/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plus>
              <c:numRef>
                <c:f>'293ptsGgalP'!$Q$116:$Q$122</c:f>
                <c:numCache>
                  <c:formatCode>General</c:formatCode>
                  <c:ptCount val="7"/>
                  <c:pt idx="0">
                    <c:v>4.5820519420888299E-3</c:v>
                  </c:pt>
                  <c:pt idx="1">
                    <c:v>2.733321262676601E-2</c:v>
                  </c:pt>
                  <c:pt idx="2">
                    <c:v>1.0818733752154161E-2</c:v>
                  </c:pt>
                  <c:pt idx="3">
                    <c:v>9.7209504743620709E-2</c:v>
                  </c:pt>
                  <c:pt idx="4">
                    <c:v>0.11821057614486111</c:v>
                  </c:pt>
                  <c:pt idx="5">
                    <c:v>6.8094383028264413E-2</c:v>
                  </c:pt>
                  <c:pt idx="6">
                    <c:v>0</c:v>
                  </c:pt>
                </c:numCache>
              </c:numRef>
            </c:plus>
            <c:minus>
              <c:numRef>
                <c:f>'293ptsGgalP'!$Q$116:$Q$122</c:f>
                <c:numCache>
                  <c:formatCode>General</c:formatCode>
                  <c:ptCount val="7"/>
                  <c:pt idx="0">
                    <c:v>4.5820519420888299E-3</c:v>
                  </c:pt>
                  <c:pt idx="1">
                    <c:v>2.733321262676601E-2</c:v>
                  </c:pt>
                  <c:pt idx="2">
                    <c:v>1.0818733752154161E-2</c:v>
                  </c:pt>
                  <c:pt idx="3">
                    <c:v>9.7209504743620709E-2</c:v>
                  </c:pt>
                  <c:pt idx="4">
                    <c:v>0.11821057614486111</c:v>
                  </c:pt>
                  <c:pt idx="5">
                    <c:v>6.8094383028264413E-2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'293ptsGgalP'!$M$116:$M$122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</c:numCache>
            </c:numRef>
          </c:xVal>
          <c:yVal>
            <c:numRef>
              <c:f>'293ptsGgalP'!$P$116:$P$122</c:f>
              <c:numCache>
                <c:formatCode>General</c:formatCode>
                <c:ptCount val="7"/>
                <c:pt idx="0">
                  <c:v>4.3380000000000016E-2</c:v>
                </c:pt>
                <c:pt idx="1">
                  <c:v>0.1304775</c:v>
                </c:pt>
                <c:pt idx="2">
                  <c:v>0.3973500000000002</c:v>
                </c:pt>
                <c:pt idx="3">
                  <c:v>0.77793749999999995</c:v>
                </c:pt>
                <c:pt idx="4">
                  <c:v>1.0661624999999999</c:v>
                </c:pt>
                <c:pt idx="5">
                  <c:v>1.0595249999999996</c:v>
                </c:pt>
                <c:pt idx="6">
                  <c:v>1.0374749999999995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'293ptsGgalP'!$AA$115</c:f>
              <c:strCache>
                <c:ptCount val="1"/>
                <c:pt idx="0">
                  <c:v>Acetato</c:v>
                </c:pt>
              </c:strCache>
            </c:strRef>
          </c:tx>
          <c:spPr>
            <a:ln w="12700"/>
          </c:spPr>
          <c:marker>
            <c:symbol val="triangle"/>
            <c:size val="3"/>
          </c:marker>
          <c:errBars>
            <c:errDir val="y"/>
            <c:errBarType val="both"/>
            <c:errValType val="cust"/>
            <c:plus>
              <c:numRef>
                <c:f>'293ptsGgalP'!$AC$116:$AC$122</c:f>
                <c:numCache>
                  <c:formatCode>General</c:formatCode>
                  <c:ptCount val="7"/>
                  <c:pt idx="0">
                    <c:v>1.4142135623730956E-2</c:v>
                  </c:pt>
                  <c:pt idx="1">
                    <c:v>5.6568542494923706E-3</c:v>
                  </c:pt>
                  <c:pt idx="2">
                    <c:v>2.9698484809834988E-2</c:v>
                  </c:pt>
                  <c:pt idx="3">
                    <c:v>1.5556349186104048E-2</c:v>
                  </c:pt>
                  <c:pt idx="4">
                    <c:v>7.9903066274079879E-2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'293ptsGgalP'!$AC$116:$AC$122</c:f>
                <c:numCache>
                  <c:formatCode>General</c:formatCode>
                  <c:ptCount val="7"/>
                  <c:pt idx="0">
                    <c:v>1.4142135623730956E-2</c:v>
                  </c:pt>
                  <c:pt idx="1">
                    <c:v>5.6568542494923706E-3</c:v>
                  </c:pt>
                  <c:pt idx="2">
                    <c:v>2.9698484809834988E-2</c:v>
                  </c:pt>
                  <c:pt idx="3">
                    <c:v>1.5556349186104048E-2</c:v>
                  </c:pt>
                  <c:pt idx="4">
                    <c:v>7.9903066274079879E-2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'293ptsGgalP'!$Y$116:$Y$122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</c:numCache>
            </c:numRef>
          </c:xVal>
          <c:yVal>
            <c:numRef>
              <c:f>'293ptsGgalP'!$AB$116:$AB$122</c:f>
              <c:numCache>
                <c:formatCode>General</c:formatCode>
                <c:ptCount val="7"/>
                <c:pt idx="0">
                  <c:v>1.0000000000000004E-2</c:v>
                </c:pt>
                <c:pt idx="1">
                  <c:v>2.5999999999999999E-2</c:v>
                </c:pt>
                <c:pt idx="2">
                  <c:v>2.1000000000000008E-2</c:v>
                </c:pt>
                <c:pt idx="3">
                  <c:v>0.127</c:v>
                </c:pt>
                <c:pt idx="4">
                  <c:v>0.15650000000000006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1"/>
        </c:ser>
        <c:axId val="44596224"/>
        <c:axId val="44606592"/>
      </c:scatterChart>
      <c:scatterChart>
        <c:scatterStyle val="smoothMarker"/>
        <c:ser>
          <c:idx val="1"/>
          <c:order val="1"/>
          <c:tx>
            <c:strRef>
              <c:f>'293ptsGgalP'!$U$115</c:f>
              <c:strCache>
                <c:ptCount val="1"/>
                <c:pt idx="0">
                  <c:v>Glucosa 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'293ptsGgalP'!$W$116:$W$122</c:f>
                <c:numCache>
                  <c:formatCode>General</c:formatCode>
                  <c:ptCount val="7"/>
                  <c:pt idx="0">
                    <c:v>7.4953318805774286E-2</c:v>
                  </c:pt>
                  <c:pt idx="1">
                    <c:v>5.9396969619670087E-2</c:v>
                  </c:pt>
                  <c:pt idx="2">
                    <c:v>2.4041630560342642E-2</c:v>
                  </c:pt>
                  <c:pt idx="3">
                    <c:v>2.4748737341529117E-2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'293ptsGgalP'!$W$116:$W$122</c:f>
                <c:numCache>
                  <c:formatCode>General</c:formatCode>
                  <c:ptCount val="7"/>
                  <c:pt idx="0">
                    <c:v>7.4953318805774286E-2</c:v>
                  </c:pt>
                  <c:pt idx="1">
                    <c:v>5.9396969619670087E-2</c:v>
                  </c:pt>
                  <c:pt idx="2">
                    <c:v>2.4041630560342642E-2</c:v>
                  </c:pt>
                  <c:pt idx="3">
                    <c:v>2.4748737341529117E-2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'293ptsGgalP'!$S$116:$S$122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</c:numCache>
            </c:numRef>
          </c:xVal>
          <c:yVal>
            <c:numRef>
              <c:f>'293ptsGgalP'!$V$116:$V$122</c:f>
              <c:numCache>
                <c:formatCode>General</c:formatCode>
                <c:ptCount val="7"/>
                <c:pt idx="0">
                  <c:v>2.6790000000000003</c:v>
                </c:pt>
                <c:pt idx="1">
                  <c:v>2.3969999999999994</c:v>
                </c:pt>
                <c:pt idx="2">
                  <c:v>1.9449999999999998</c:v>
                </c:pt>
                <c:pt idx="3">
                  <c:v>1.0054999999999996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1"/>
        </c:ser>
        <c:axId val="44622976"/>
        <c:axId val="44608512"/>
      </c:scatterChart>
      <c:valAx>
        <c:axId val="44596224"/>
        <c:scaling>
          <c:orientation val="minMax"/>
          <c:max val="10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Time (h)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4606592"/>
        <c:crosses val="autoZero"/>
        <c:crossBetween val="midCat"/>
        <c:majorUnit val="2"/>
      </c:valAx>
      <c:valAx>
        <c:axId val="44606592"/>
        <c:scaling>
          <c:orientation val="minMax"/>
          <c:min val="0"/>
        </c:scaling>
        <c:axPos val="l"/>
        <c:majorGridlines>
          <c:spPr>
            <a:ln w="0"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Biomass, Acetate</a:t>
                </a:r>
                <a:endParaRPr lang="es-MX" sz="700" dirty="0" smtClean="0">
                  <a:effectLst/>
                </a:endParaRPr>
              </a:p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4596224"/>
        <c:crosses val="autoZero"/>
        <c:crossBetween val="midCat"/>
      </c:valAx>
      <c:valAx>
        <c:axId val="44608512"/>
        <c:scaling>
          <c:orientation val="minMax"/>
          <c:min val="0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4622976"/>
        <c:crosses val="max"/>
        <c:crossBetween val="midCat"/>
      </c:valAx>
      <c:valAx>
        <c:axId val="44622976"/>
        <c:scaling>
          <c:orientation val="minMax"/>
        </c:scaling>
        <c:delete val="1"/>
        <c:axPos val="b"/>
        <c:numFmt formatCode="General" sourceLinked="1"/>
        <c:tickLblPos val="none"/>
        <c:crossAx val="44608512"/>
        <c:crosses val="autoZero"/>
        <c:crossBetween val="midCat"/>
      </c:valAx>
    </c:plotArea>
    <c:plotVisOnly val="1"/>
    <c:dispBlanksAs val="gap"/>
  </c:chart>
  <c:externalData r:id="rId1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scatterChart>
        <c:scatterStyle val="smoothMarker"/>
        <c:ser>
          <c:idx val="0"/>
          <c:order val="0"/>
          <c:tx>
            <c:strRef>
              <c:f>pGXgalP!$O$97</c:f>
              <c:strCache>
                <c:ptCount val="1"/>
                <c:pt idx="0">
                  <c:v>Biomasa</c:v>
                </c:pt>
              </c:strCache>
            </c:strRef>
          </c:tx>
          <c:spPr>
            <a:ln w="12700"/>
          </c:spPr>
          <c:marker>
            <c:symbol val="diamond"/>
            <c:size val="3"/>
            <c:spPr>
              <a:ln w="12700"/>
            </c:spPr>
          </c:marker>
          <c:errBars>
            <c:errDir val="y"/>
            <c:errBarType val="both"/>
            <c:errValType val="cust"/>
            <c:plus>
              <c:numRef>
                <c:f>pGXgalP!$P$98:$P$104</c:f>
                <c:numCache>
                  <c:formatCode>General</c:formatCode>
                  <c:ptCount val="7"/>
                  <c:pt idx="0">
                    <c:v>2.7646021413577802E-3</c:v>
                  </c:pt>
                  <c:pt idx="1">
                    <c:v>2.6608105907786801E-2</c:v>
                  </c:pt>
                  <c:pt idx="2">
                    <c:v>0.12678631876113566</c:v>
                  </c:pt>
                  <c:pt idx="3">
                    <c:v>0.12446506497808944</c:v>
                  </c:pt>
                  <c:pt idx="4">
                    <c:v>9.6321376132196129E-2</c:v>
                  </c:pt>
                  <c:pt idx="5">
                    <c:v>3.1819805153398997E-4</c:v>
                  </c:pt>
                  <c:pt idx="6">
                    <c:v>0</c:v>
                  </c:pt>
                </c:numCache>
              </c:numRef>
            </c:plus>
            <c:minus>
              <c:numRef>
                <c:f>pGXgalP!$P$98:$P$104</c:f>
                <c:numCache>
                  <c:formatCode>General</c:formatCode>
                  <c:ptCount val="7"/>
                  <c:pt idx="0">
                    <c:v>2.7646021413577802E-3</c:v>
                  </c:pt>
                  <c:pt idx="1">
                    <c:v>2.6608105907786801E-2</c:v>
                  </c:pt>
                  <c:pt idx="2">
                    <c:v>0.12678631876113566</c:v>
                  </c:pt>
                  <c:pt idx="3">
                    <c:v>0.12446506497808944</c:v>
                  </c:pt>
                  <c:pt idx="4">
                    <c:v>9.6321376132196129E-2</c:v>
                  </c:pt>
                  <c:pt idx="5">
                    <c:v>3.1819805153398997E-4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pGXgalP!$K$98:$K$103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pGXgalP!$O$98:$O$103</c:f>
              <c:numCache>
                <c:formatCode>General</c:formatCode>
                <c:ptCount val="6"/>
                <c:pt idx="0">
                  <c:v>4.6424999999999987E-2</c:v>
                </c:pt>
                <c:pt idx="1">
                  <c:v>0.13416</c:v>
                </c:pt>
                <c:pt idx="2">
                  <c:v>0.70237499999999997</c:v>
                </c:pt>
                <c:pt idx="3">
                  <c:v>1.36338</c:v>
                </c:pt>
                <c:pt idx="4">
                  <c:v>1.3463250000000002</c:v>
                </c:pt>
                <c:pt idx="5">
                  <c:v>1.3491</c:v>
                </c:pt>
              </c:numCache>
            </c:numRef>
          </c:yVal>
          <c:smooth val="1"/>
        </c:ser>
        <c:axId val="45444480"/>
        <c:axId val="45446656"/>
      </c:scatterChart>
      <c:scatterChart>
        <c:scatterStyle val="smoothMarker"/>
        <c:ser>
          <c:idx val="1"/>
          <c:order val="1"/>
          <c:tx>
            <c:strRef>
              <c:f>pGXgalP!$V$97</c:f>
              <c:strCache>
                <c:ptCount val="1"/>
                <c:pt idx="0">
                  <c:v>Glucosa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pGXgalP!$W$98:$W$104</c:f>
                <c:numCache>
                  <c:formatCode>General</c:formatCode>
                  <c:ptCount val="7"/>
                  <c:pt idx="0">
                    <c:v>6.8704682033565334E-2</c:v>
                  </c:pt>
                  <c:pt idx="1">
                    <c:v>0.1304811608368554</c:v>
                  </c:pt>
                  <c:pt idx="2">
                    <c:v>0.16974097914174999</c:v>
                  </c:pt>
                  <c:pt idx="3">
                    <c:v>2.8867513459481312E-3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pGXgalP!$W$98:$W$104</c:f>
                <c:numCache>
                  <c:formatCode>General</c:formatCode>
                  <c:ptCount val="7"/>
                  <c:pt idx="0">
                    <c:v>6.8704682033565334E-2</c:v>
                  </c:pt>
                  <c:pt idx="1">
                    <c:v>0.1304811608368554</c:v>
                  </c:pt>
                  <c:pt idx="2">
                    <c:v>0.16974097914174999</c:v>
                  </c:pt>
                  <c:pt idx="3">
                    <c:v>2.8867513459481312E-3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pGXgalP!$R$98:$R$103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</c:numCache>
            </c:numRef>
          </c:xVal>
          <c:yVal>
            <c:numRef>
              <c:f>pGXgalP!$V$98:$V$103</c:f>
              <c:numCache>
                <c:formatCode>General</c:formatCode>
                <c:ptCount val="6"/>
                <c:pt idx="0">
                  <c:v>2.7243333333333344</c:v>
                </c:pt>
                <c:pt idx="1">
                  <c:v>2.3893333333333335</c:v>
                </c:pt>
                <c:pt idx="2">
                  <c:v>1.5199999999999994</c:v>
                </c:pt>
                <c:pt idx="3">
                  <c:v>0.2166666666666667</c:v>
                </c:pt>
                <c:pt idx="4">
                  <c:v>0</c:v>
                </c:pt>
                <c:pt idx="5">
                  <c:v>0</c:v>
                </c:pt>
              </c:numCache>
            </c:numRef>
          </c:yVal>
          <c:smooth val="1"/>
        </c:ser>
        <c:axId val="45471232"/>
        <c:axId val="45448576"/>
      </c:scatterChart>
      <c:valAx>
        <c:axId val="45444480"/>
        <c:scaling>
          <c:orientation val="minMax"/>
          <c:max val="20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Time (h)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5446656"/>
        <c:crosses val="autoZero"/>
        <c:crossBetween val="midCat"/>
        <c:majorUnit val="4"/>
      </c:valAx>
      <c:valAx>
        <c:axId val="45446656"/>
        <c:scaling>
          <c:orientation val="minMax"/>
          <c:min val="0"/>
        </c:scaling>
        <c:axPos val="l"/>
        <c:majorGridlines>
          <c:spPr>
            <a:ln w="0"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Biomass</a:t>
                </a:r>
                <a:endParaRPr lang="es-MX" sz="700" dirty="0" smtClean="0">
                  <a:effectLst/>
                </a:endParaRPr>
              </a:p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5444480"/>
        <c:crosses val="autoZero"/>
        <c:crossBetween val="midCat"/>
      </c:valAx>
      <c:valAx>
        <c:axId val="45448576"/>
        <c:scaling>
          <c:orientation val="minMax"/>
          <c:min val="0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5471232"/>
        <c:crosses val="max"/>
        <c:crossBetween val="midCat"/>
      </c:valAx>
      <c:valAx>
        <c:axId val="45471232"/>
        <c:scaling>
          <c:orientation val="minMax"/>
        </c:scaling>
        <c:delete val="1"/>
        <c:axPos val="b"/>
        <c:numFmt formatCode="General" sourceLinked="1"/>
        <c:tickLblPos val="none"/>
        <c:crossAx val="45448576"/>
        <c:crosses val="autoZero"/>
        <c:crossBetween val="midCat"/>
      </c:valAx>
    </c:plotArea>
    <c:plotVisOnly val="1"/>
    <c:dispBlanksAs val="gap"/>
  </c:chart>
  <c:externalData r:id="rId1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scatterChart>
        <c:scatterStyle val="smoothMarker"/>
        <c:ser>
          <c:idx val="0"/>
          <c:order val="0"/>
          <c:tx>
            <c:strRef>
              <c:f>'283ptsGmanXABC'!$U$116</c:f>
              <c:strCache>
                <c:ptCount val="1"/>
                <c:pt idx="0">
                  <c:v>promedio</c:v>
                </c:pt>
              </c:strCache>
            </c:strRef>
          </c:tx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plus>
              <c:numRef>
                <c:f>'283ptsGmanXABC'!$V$117:$V$123</c:f>
                <c:numCache>
                  <c:formatCode>General</c:formatCode>
                  <c:ptCount val="7"/>
                  <c:pt idx="0">
                    <c:v>2.1856292000245617E-3</c:v>
                  </c:pt>
                  <c:pt idx="1">
                    <c:v>6.1707454979119175E-3</c:v>
                  </c:pt>
                  <c:pt idx="2">
                    <c:v>2.4878828348618025E-2</c:v>
                  </c:pt>
                  <c:pt idx="3">
                    <c:v>7.5268581592853254E-2</c:v>
                  </c:pt>
                  <c:pt idx="4">
                    <c:v>9.9652480526076351E-2</c:v>
                  </c:pt>
                  <c:pt idx="5">
                    <c:v>0.16434929361728146</c:v>
                  </c:pt>
                  <c:pt idx="6">
                    <c:v>9.1252130112124033E-2</c:v>
                  </c:pt>
                </c:numCache>
              </c:numRef>
            </c:plus>
            <c:minus>
              <c:numRef>
                <c:f>'283ptsGmanXABC'!$V$117:$V$123</c:f>
                <c:numCache>
                  <c:formatCode>General</c:formatCode>
                  <c:ptCount val="7"/>
                  <c:pt idx="0">
                    <c:v>2.1856292000245617E-3</c:v>
                  </c:pt>
                  <c:pt idx="1">
                    <c:v>6.1707454979119175E-3</c:v>
                  </c:pt>
                  <c:pt idx="2">
                    <c:v>2.4878828348618025E-2</c:v>
                  </c:pt>
                  <c:pt idx="3">
                    <c:v>7.5268581592853254E-2</c:v>
                  </c:pt>
                  <c:pt idx="4">
                    <c:v>9.9652480526076351E-2</c:v>
                  </c:pt>
                  <c:pt idx="5">
                    <c:v>0.16434929361728146</c:v>
                  </c:pt>
                  <c:pt idx="6">
                    <c:v>9.1252130112124033E-2</c:v>
                  </c:pt>
                </c:numCache>
              </c:numRef>
            </c:minus>
          </c:errBars>
          <c:xVal>
            <c:numRef>
              <c:f>'283ptsGmanXABC'!$Q$117:$Q$123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</c:numCache>
            </c:numRef>
          </c:xVal>
          <c:yVal>
            <c:numRef>
              <c:f>'283ptsGmanXABC'!$U$117:$U$123</c:f>
              <c:numCache>
                <c:formatCode>General</c:formatCode>
                <c:ptCount val="7"/>
                <c:pt idx="0">
                  <c:v>4.7250000000000007E-2</c:v>
                </c:pt>
                <c:pt idx="1">
                  <c:v>0.11592000000000002</c:v>
                </c:pt>
                <c:pt idx="2">
                  <c:v>0.30090000000000011</c:v>
                </c:pt>
                <c:pt idx="3">
                  <c:v>0.78442500000000004</c:v>
                </c:pt>
                <c:pt idx="4">
                  <c:v>1.0634249999999996</c:v>
                </c:pt>
                <c:pt idx="5">
                  <c:v>1.0099125</c:v>
                </c:pt>
                <c:pt idx="6">
                  <c:v>1.0645250000000002</c:v>
                </c:pt>
              </c:numCache>
            </c:numRef>
          </c:yVal>
          <c:smooth val="1"/>
        </c:ser>
        <c:axId val="46112768"/>
        <c:axId val="46114688"/>
      </c:scatterChart>
      <c:scatterChart>
        <c:scatterStyle val="smoothMarker"/>
        <c:ser>
          <c:idx val="1"/>
          <c:order val="1"/>
          <c:tx>
            <c:strRef>
              <c:f>'283ptsGmanXABC'!$M$116</c:f>
              <c:strCache>
                <c:ptCount val="1"/>
                <c:pt idx="0">
                  <c:v>Glucosa 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'283ptsGmanXABC'!$O$117:$O$123</c:f>
                <c:numCache>
                  <c:formatCode>General</c:formatCode>
                  <c:ptCount val="7"/>
                  <c:pt idx="0">
                    <c:v>0.13859292911256343</c:v>
                  </c:pt>
                  <c:pt idx="1">
                    <c:v>0.13152186130069773</c:v>
                  </c:pt>
                  <c:pt idx="2">
                    <c:v>0.48295393155041166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'283ptsGmanXABC'!$O$117:$O$123</c:f>
                <c:numCache>
                  <c:formatCode>General</c:formatCode>
                  <c:ptCount val="7"/>
                  <c:pt idx="0">
                    <c:v>0.13859292911256343</c:v>
                  </c:pt>
                  <c:pt idx="1">
                    <c:v>0.13152186130069773</c:v>
                  </c:pt>
                  <c:pt idx="2">
                    <c:v>0.48295393155041166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'283ptsGmanXABC'!$K$117:$K$123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</c:numCache>
            </c:numRef>
          </c:xVal>
          <c:yVal>
            <c:numRef>
              <c:f>'283ptsGmanXABC'!$N$117:$N$123</c:f>
              <c:numCache>
                <c:formatCode>General</c:formatCode>
                <c:ptCount val="7"/>
                <c:pt idx="0">
                  <c:v>2.7350000000000003</c:v>
                </c:pt>
                <c:pt idx="1">
                  <c:v>2.609</c:v>
                </c:pt>
                <c:pt idx="2">
                  <c:v>2.0605000000000002</c:v>
                </c:pt>
                <c:pt idx="3">
                  <c:v>1.2829999999999995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1"/>
        </c:ser>
        <c:axId val="46122880"/>
        <c:axId val="46120960"/>
      </c:scatterChart>
      <c:valAx>
        <c:axId val="4611276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Time (h)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6114688"/>
        <c:crosses val="autoZero"/>
        <c:crossBetween val="midCat"/>
        <c:majorUnit val="4"/>
      </c:valAx>
      <c:valAx>
        <c:axId val="46114688"/>
        <c:scaling>
          <c:orientation val="minMax"/>
        </c:scaling>
        <c:axPos val="l"/>
        <c:majorGridlines>
          <c:spPr>
            <a:ln w="0"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Biomass</a:t>
                </a:r>
                <a:endParaRPr lang="es-MX" sz="700" dirty="0" smtClean="0">
                  <a:effectLst/>
                </a:endParaRPr>
              </a:p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6112768"/>
        <c:crosses val="autoZero"/>
        <c:crossBetween val="midCat"/>
      </c:valAx>
      <c:valAx>
        <c:axId val="46120960"/>
        <c:scaling>
          <c:orientation val="minMax"/>
          <c:min val="0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6122880"/>
        <c:crosses val="max"/>
        <c:crossBetween val="midCat"/>
      </c:valAx>
      <c:valAx>
        <c:axId val="46122880"/>
        <c:scaling>
          <c:orientation val="minMax"/>
        </c:scaling>
        <c:delete val="1"/>
        <c:axPos val="b"/>
        <c:numFmt formatCode="General" sourceLinked="1"/>
        <c:tickLblPos val="none"/>
        <c:crossAx val="46120960"/>
        <c:crosses val="autoZero"/>
        <c:crossBetween val="midCat"/>
      </c:valAx>
    </c:plotArea>
    <c:plotVisOnly val="1"/>
    <c:dispBlanksAs val="gap"/>
  </c:chart>
  <c:externalData r:id="rId1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scatterChart>
        <c:scatterStyle val="smoothMarker"/>
        <c:ser>
          <c:idx val="0"/>
          <c:order val="0"/>
          <c:tx>
            <c:strRef>
              <c:f>PTS!$N$107</c:f>
              <c:strCache>
                <c:ptCount val="1"/>
                <c:pt idx="0">
                  <c:v>Biomasa</c:v>
                </c:pt>
              </c:strCache>
            </c:strRef>
          </c:tx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plus>
              <c:numRef>
                <c:f>PTS!$O$108:$O$114</c:f>
                <c:numCache>
                  <c:formatCode>General</c:formatCode>
                  <c:ptCount val="7"/>
                  <c:pt idx="0">
                    <c:v>3.0026613195630312E-3</c:v>
                  </c:pt>
                  <c:pt idx="1">
                    <c:v>2.1449113618049617E-2</c:v>
                  </c:pt>
                  <c:pt idx="2">
                    <c:v>8.2558849919315364E-2</c:v>
                  </c:pt>
                  <c:pt idx="3">
                    <c:v>0.11578410804164799</c:v>
                  </c:pt>
                  <c:pt idx="4">
                    <c:v>7.2238783731455522E-2</c:v>
                  </c:pt>
                  <c:pt idx="5">
                    <c:v>4.8676155610319037E-2</c:v>
                  </c:pt>
                  <c:pt idx="6">
                    <c:v>6.9208076208633326E-2</c:v>
                  </c:pt>
                </c:numCache>
              </c:numRef>
            </c:plus>
            <c:minus>
              <c:numRef>
                <c:f>PTS!$O$108:$O$114</c:f>
                <c:numCache>
                  <c:formatCode>General</c:formatCode>
                  <c:ptCount val="7"/>
                  <c:pt idx="0">
                    <c:v>3.0026613195630312E-3</c:v>
                  </c:pt>
                  <c:pt idx="1">
                    <c:v>2.1449113618049617E-2</c:v>
                  </c:pt>
                  <c:pt idx="2">
                    <c:v>8.2558849919315364E-2</c:v>
                  </c:pt>
                  <c:pt idx="3">
                    <c:v>0.11578410804164799</c:v>
                  </c:pt>
                  <c:pt idx="4">
                    <c:v>7.2238783731455522E-2</c:v>
                  </c:pt>
                  <c:pt idx="5">
                    <c:v>4.8676155610319037E-2</c:v>
                  </c:pt>
                  <c:pt idx="6">
                    <c:v>6.9208076208633326E-2</c:v>
                  </c:pt>
                </c:numCache>
              </c:numRef>
            </c:minus>
          </c:errBars>
          <c:xVal>
            <c:numRef>
              <c:f>PTS!$J$108:$J$114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PTS!$N$108:$N$114</c:f>
              <c:numCache>
                <c:formatCode>General</c:formatCode>
                <c:ptCount val="7"/>
                <c:pt idx="0">
                  <c:v>4.6335000000000008E-2</c:v>
                </c:pt>
                <c:pt idx="1">
                  <c:v>0.12216000000000003</c:v>
                </c:pt>
                <c:pt idx="2">
                  <c:v>0.35658000000000012</c:v>
                </c:pt>
                <c:pt idx="3">
                  <c:v>0.94873500000000033</c:v>
                </c:pt>
                <c:pt idx="4">
                  <c:v>1.2642</c:v>
                </c:pt>
                <c:pt idx="5">
                  <c:v>1.24275</c:v>
                </c:pt>
                <c:pt idx="6">
                  <c:v>1.3460624999999999</c:v>
                </c:pt>
              </c:numCache>
            </c:numRef>
          </c:yVal>
          <c:smooth val="1"/>
        </c:ser>
        <c:axId val="46240128"/>
        <c:axId val="46242048"/>
      </c:scatterChart>
      <c:scatterChart>
        <c:scatterStyle val="smoothMarker"/>
        <c:ser>
          <c:idx val="1"/>
          <c:order val="1"/>
          <c:tx>
            <c:strRef>
              <c:f>PTS!$U$107</c:f>
              <c:strCache>
                <c:ptCount val="1"/>
                <c:pt idx="0">
                  <c:v>Glucosa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PTS!$V$108:$V$115</c:f>
                <c:numCache>
                  <c:formatCode>General</c:formatCode>
                  <c:ptCount val="8"/>
                  <c:pt idx="0">
                    <c:v>7.5434298123157009E-2</c:v>
                  </c:pt>
                  <c:pt idx="1">
                    <c:v>0.15475895235279066</c:v>
                  </c:pt>
                  <c:pt idx="2">
                    <c:v>0.26542858424317212</c:v>
                  </c:pt>
                  <c:pt idx="3">
                    <c:v>0.38227913013050202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plus>
            <c:minus>
              <c:numRef>
                <c:f>PTS!$V$108:$V$115</c:f>
                <c:numCache>
                  <c:formatCode>General</c:formatCode>
                  <c:ptCount val="8"/>
                  <c:pt idx="0">
                    <c:v>7.5434298123157009E-2</c:v>
                  </c:pt>
                  <c:pt idx="1">
                    <c:v>0.15475895235279066</c:v>
                  </c:pt>
                  <c:pt idx="2">
                    <c:v>0.26542858424317212</c:v>
                  </c:pt>
                  <c:pt idx="3">
                    <c:v>0.38227913013050202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minus>
          </c:errBars>
          <c:xVal>
            <c:numRef>
              <c:f>PTS!$Q$108:$Q$114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PTS!$U$108:$U$114</c:f>
              <c:numCache>
                <c:formatCode>General</c:formatCode>
                <c:ptCount val="7"/>
                <c:pt idx="0">
                  <c:v>2.4603333333333341</c:v>
                </c:pt>
                <c:pt idx="1">
                  <c:v>2.3226666666666667</c:v>
                </c:pt>
                <c:pt idx="2">
                  <c:v>2.0316666666666667</c:v>
                </c:pt>
                <c:pt idx="3">
                  <c:v>0.42533333333333334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1"/>
        </c:ser>
        <c:axId val="46262528"/>
        <c:axId val="46260608"/>
      </c:scatterChart>
      <c:valAx>
        <c:axId val="46240128"/>
        <c:scaling>
          <c:orientation val="minMax"/>
          <c:max val="24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u="none" strike="noStrike" baseline="0" dirty="0" smtClean="0">
                    <a:effectLst/>
                  </a:rPr>
                  <a:t>Time (h)</a:t>
                </a:r>
                <a:endParaRPr lang="es-MX" sz="700" dirty="0"/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6242048"/>
        <c:crosses val="autoZero"/>
        <c:crossBetween val="midCat"/>
        <c:majorUnit val="4"/>
      </c:valAx>
      <c:valAx>
        <c:axId val="46242048"/>
        <c:scaling>
          <c:orientation val="minMax"/>
        </c:scaling>
        <c:axPos val="l"/>
        <c:majorGridlines>
          <c:spPr>
            <a:ln w="0"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Biomass</a:t>
                </a:r>
                <a:endParaRPr lang="es-MX" sz="700" dirty="0" smtClean="0">
                  <a:effectLst/>
                </a:endParaRPr>
              </a:p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6240128"/>
        <c:crosses val="autoZero"/>
        <c:crossBetween val="midCat"/>
      </c:valAx>
      <c:valAx>
        <c:axId val="46260608"/>
        <c:scaling>
          <c:orientation val="minMax"/>
          <c:min val="0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6262528"/>
        <c:crosses val="max"/>
        <c:crossBetween val="midCat"/>
      </c:valAx>
      <c:valAx>
        <c:axId val="46262528"/>
        <c:scaling>
          <c:orientation val="minMax"/>
        </c:scaling>
        <c:delete val="1"/>
        <c:axPos val="b"/>
        <c:numFmt formatCode="General" sourceLinked="1"/>
        <c:tickLblPos val="none"/>
        <c:crossAx val="46260608"/>
        <c:crosses val="autoZero"/>
        <c:crossBetween val="midCat"/>
      </c:valAx>
    </c:plotArea>
    <c:plotVisOnly val="1"/>
    <c:dispBlanksAs val="gap"/>
  </c:chart>
  <c:externalData r:id="rId1"/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scatterChart>
        <c:scatterStyle val="smoothMarker"/>
        <c:ser>
          <c:idx val="1"/>
          <c:order val="1"/>
          <c:tx>
            <c:strRef>
              <c:f>PTSgalP!$V$58</c:f>
              <c:strCache>
                <c:ptCount val="1"/>
                <c:pt idx="0">
                  <c:v>Glucosa 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PTSgalP!$X$59:$X$67</c:f>
                <c:numCache>
                  <c:formatCode>General</c:formatCode>
                  <c:ptCount val="9"/>
                  <c:pt idx="0">
                    <c:v>3.9878983604567278E-2</c:v>
                  </c:pt>
                  <c:pt idx="1">
                    <c:v>0.11389615152994993</c:v>
                  </c:pt>
                  <c:pt idx="2">
                    <c:v>0.23057392162456983</c:v>
                  </c:pt>
                  <c:pt idx="3">
                    <c:v>0.25265853109153963</c:v>
                  </c:pt>
                  <c:pt idx="4">
                    <c:v>0.3323401871576776</c:v>
                  </c:pt>
                  <c:pt idx="5">
                    <c:v>0.18343754613855176</c:v>
                  </c:pt>
                  <c:pt idx="6">
                    <c:v>0.11113205358191368</c:v>
                  </c:pt>
                  <c:pt idx="7">
                    <c:v>1.2701705922171763E-2</c:v>
                  </c:pt>
                  <c:pt idx="8">
                    <c:v>0</c:v>
                  </c:pt>
                </c:numCache>
              </c:numRef>
            </c:plus>
            <c:minus>
              <c:numRef>
                <c:f>PTSgalP!$X$59:$X$67</c:f>
                <c:numCache>
                  <c:formatCode>General</c:formatCode>
                  <c:ptCount val="9"/>
                  <c:pt idx="0">
                    <c:v>3.9878983604567278E-2</c:v>
                  </c:pt>
                  <c:pt idx="1">
                    <c:v>0.11389615152994993</c:v>
                  </c:pt>
                  <c:pt idx="2">
                    <c:v>0.23057392162456983</c:v>
                  </c:pt>
                  <c:pt idx="3">
                    <c:v>0.25265853109153963</c:v>
                  </c:pt>
                  <c:pt idx="4">
                    <c:v>0.3323401871576776</c:v>
                  </c:pt>
                  <c:pt idx="5">
                    <c:v>0.18343754613855176</c:v>
                  </c:pt>
                  <c:pt idx="6">
                    <c:v>0.11113205358191368</c:v>
                  </c:pt>
                  <c:pt idx="7">
                    <c:v>1.2701705922171763E-2</c:v>
                  </c:pt>
                  <c:pt idx="8">
                    <c:v>0</c:v>
                  </c:pt>
                </c:numCache>
              </c:numRef>
            </c:minus>
          </c:errBars>
          <c:xVal>
            <c:numRef>
              <c:f>PTSgalP!$S$59:$S$67</c:f>
              <c:numCache>
                <c:formatCode>General</c:formatCode>
                <c:ptCount val="9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</c:numCache>
            </c:numRef>
          </c:xVal>
          <c:yVal>
            <c:numRef>
              <c:f>PTSgalP!$W$59:$W$67</c:f>
              <c:numCache>
                <c:formatCode>General</c:formatCode>
                <c:ptCount val="9"/>
                <c:pt idx="0">
                  <c:v>2.4366666666666661</c:v>
                </c:pt>
                <c:pt idx="1">
                  <c:v>2.2876666666666674</c:v>
                </c:pt>
                <c:pt idx="2">
                  <c:v>2.0583333333333336</c:v>
                </c:pt>
                <c:pt idx="3">
                  <c:v>1.7436666666666663</c:v>
                </c:pt>
                <c:pt idx="4">
                  <c:v>0.9750000000000002</c:v>
                </c:pt>
                <c:pt idx="5">
                  <c:v>0.56533333333333335</c:v>
                </c:pt>
                <c:pt idx="6">
                  <c:v>0.21733333333333343</c:v>
                </c:pt>
                <c:pt idx="7">
                  <c:v>2.1999999999999999E-2</c:v>
                </c:pt>
                <c:pt idx="8">
                  <c:v>0</c:v>
                </c:pt>
              </c:numCache>
            </c:numRef>
          </c:yVal>
          <c:smooth val="1"/>
        </c:ser>
        <c:axId val="46576384"/>
        <c:axId val="46578304"/>
      </c:scatterChart>
      <c:scatterChart>
        <c:scatterStyle val="smoothMarker"/>
        <c:ser>
          <c:idx val="0"/>
          <c:order val="0"/>
          <c:tx>
            <c:strRef>
              <c:f>PTSgalP!$P$58</c:f>
              <c:strCache>
                <c:ptCount val="1"/>
                <c:pt idx="0">
                  <c:v>promedio</c:v>
                </c:pt>
              </c:strCache>
            </c:strRef>
          </c:tx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plus>
              <c:numRef>
                <c:f>PTSgalP!$Q$59:$Q$67</c:f>
                <c:numCache>
                  <c:formatCode>General</c:formatCode>
                  <c:ptCount val="9"/>
                  <c:pt idx="0">
                    <c:v>4.4319860108082249E-4</c:v>
                  </c:pt>
                  <c:pt idx="1">
                    <c:v>2.5664324947288181E-2</c:v>
                  </c:pt>
                  <c:pt idx="2">
                    <c:v>7.1685946321437322E-2</c:v>
                  </c:pt>
                  <c:pt idx="3">
                    <c:v>0.14107017695104807</c:v>
                  </c:pt>
                  <c:pt idx="4">
                    <c:v>0.16291740238538141</c:v>
                  </c:pt>
                  <c:pt idx="5">
                    <c:v>5.5801360870502199E-2</c:v>
                  </c:pt>
                  <c:pt idx="6">
                    <c:v>0.16892947256177676</c:v>
                  </c:pt>
                  <c:pt idx="7">
                    <c:v>0.12682205052750106</c:v>
                  </c:pt>
                  <c:pt idx="8">
                    <c:v>3.0547012947258954E-2</c:v>
                  </c:pt>
                </c:numCache>
              </c:numRef>
            </c:plus>
            <c:minus>
              <c:numRef>
                <c:f>PTSgalP!$Q$59:$Q$67</c:f>
                <c:numCache>
                  <c:formatCode>General</c:formatCode>
                  <c:ptCount val="9"/>
                  <c:pt idx="0">
                    <c:v>4.4319860108082249E-4</c:v>
                  </c:pt>
                  <c:pt idx="1">
                    <c:v>2.5664324947288181E-2</c:v>
                  </c:pt>
                  <c:pt idx="2">
                    <c:v>7.1685946321437322E-2</c:v>
                  </c:pt>
                  <c:pt idx="3">
                    <c:v>0.14107017695104807</c:v>
                  </c:pt>
                  <c:pt idx="4">
                    <c:v>0.16291740238538141</c:v>
                  </c:pt>
                  <c:pt idx="5">
                    <c:v>5.5801360870502199E-2</c:v>
                  </c:pt>
                  <c:pt idx="6">
                    <c:v>0.16892947256177676</c:v>
                  </c:pt>
                  <c:pt idx="7">
                    <c:v>0.12682205052750106</c:v>
                  </c:pt>
                  <c:pt idx="8">
                    <c:v>3.0547012947258954E-2</c:v>
                  </c:pt>
                </c:numCache>
              </c:numRef>
            </c:minus>
          </c:errBars>
          <c:xVal>
            <c:numRef>
              <c:f>PTSgalP!$L$59:$L$67</c:f>
              <c:numCache>
                <c:formatCode>General</c:formatCode>
                <c:ptCount val="9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  <c:pt idx="7">
                  <c:v>28</c:v>
                </c:pt>
                <c:pt idx="8">
                  <c:v>32</c:v>
                </c:pt>
              </c:numCache>
            </c:numRef>
          </c:xVal>
          <c:yVal>
            <c:numRef>
              <c:f>PTSgalP!$P$59:$P$67</c:f>
              <c:numCache>
                <c:formatCode>General</c:formatCode>
                <c:ptCount val="9"/>
                <c:pt idx="0">
                  <c:v>4.5720000000000004E-2</c:v>
                </c:pt>
                <c:pt idx="1">
                  <c:v>0.10237500000000002</c:v>
                </c:pt>
                <c:pt idx="2">
                  <c:v>0.21789000000000008</c:v>
                </c:pt>
                <c:pt idx="3">
                  <c:v>0.43812000000000018</c:v>
                </c:pt>
                <c:pt idx="4">
                  <c:v>0.83519999999999994</c:v>
                </c:pt>
                <c:pt idx="5">
                  <c:v>1.0433249999999996</c:v>
                </c:pt>
                <c:pt idx="6">
                  <c:v>1.2211199999999998</c:v>
                </c:pt>
                <c:pt idx="7">
                  <c:v>1.4015999999999997</c:v>
                </c:pt>
                <c:pt idx="8">
                  <c:v>1.3680000000000001</c:v>
                </c:pt>
              </c:numCache>
            </c:numRef>
          </c:yVal>
          <c:smooth val="1"/>
        </c:ser>
        <c:axId val="46594688"/>
        <c:axId val="46592768"/>
      </c:scatterChart>
      <c:valAx>
        <c:axId val="46576384"/>
        <c:scaling>
          <c:orientation val="minMax"/>
          <c:max val="32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Time (h)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6578304"/>
        <c:crosses val="autoZero"/>
        <c:crossBetween val="midCat"/>
        <c:majorUnit val="4"/>
      </c:valAx>
      <c:valAx>
        <c:axId val="46578304"/>
        <c:scaling>
          <c:orientation val="minMax"/>
          <c:min val="0"/>
        </c:scaling>
        <c:axPos val="l"/>
        <c:majorGridlines>
          <c:spPr>
            <a:ln w="0"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Biomass</a:t>
                </a:r>
                <a:endParaRPr lang="es-MX" sz="700" dirty="0" smtClean="0">
                  <a:effectLst/>
                </a:endParaRPr>
              </a:p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6576384"/>
        <c:crosses val="autoZero"/>
        <c:crossBetween val="midCat"/>
      </c:valAx>
      <c:valAx>
        <c:axId val="46592768"/>
        <c:scaling>
          <c:orientation val="minMax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6594688"/>
        <c:crosses val="max"/>
        <c:crossBetween val="midCat"/>
      </c:valAx>
      <c:valAx>
        <c:axId val="46594688"/>
        <c:scaling>
          <c:orientation val="minMax"/>
        </c:scaling>
        <c:delete val="1"/>
        <c:axPos val="b"/>
        <c:numFmt formatCode="General" sourceLinked="1"/>
        <c:tickLblPos val="none"/>
        <c:crossAx val="46592768"/>
        <c:crosses val="autoZero"/>
        <c:crossBetween val="midCat"/>
      </c:valAx>
    </c:plotArea>
    <c:plotVisOnly val="1"/>
    <c:dispBlanksAs val="gap"/>
  </c:chart>
  <c:externalData r:id="rId1"/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scatterChart>
        <c:scatterStyle val="smoothMarker"/>
        <c:ser>
          <c:idx val="0"/>
          <c:order val="0"/>
          <c:tx>
            <c:strRef>
              <c:f>'287PTSmABC'!$O$117</c:f>
              <c:strCache>
                <c:ptCount val="1"/>
                <c:pt idx="0">
                  <c:v>promedio</c:v>
                </c:pt>
              </c:strCache>
            </c:strRef>
          </c:tx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plus>
              <c:numRef>
                <c:f>'287PTSmABC'!$P$118:$P$126</c:f>
                <c:numCache>
                  <c:formatCode>General</c:formatCode>
                  <c:ptCount val="9"/>
                  <c:pt idx="0">
                    <c:v>3.1819805153394595E-4</c:v>
                  </c:pt>
                  <c:pt idx="1">
                    <c:v>6.9685373285934297E-3</c:v>
                  </c:pt>
                  <c:pt idx="2">
                    <c:v>2.1542008088848142E-2</c:v>
                  </c:pt>
                  <c:pt idx="3">
                    <c:v>8.1140503141156027E-3</c:v>
                  </c:pt>
                  <c:pt idx="4">
                    <c:v>6.5230600564458504E-3</c:v>
                  </c:pt>
                  <c:pt idx="5">
                    <c:v>1.8932784066269734E-2</c:v>
                  </c:pt>
                  <c:pt idx="6">
                    <c:v>0.12282444789210328</c:v>
                  </c:pt>
                  <c:pt idx="7">
                    <c:v>0.16864496731299158</c:v>
                  </c:pt>
                  <c:pt idx="8">
                    <c:v>0</c:v>
                  </c:pt>
                </c:numCache>
              </c:numRef>
            </c:plus>
            <c:minus>
              <c:numRef>
                <c:f>'287PTSmABC'!$P$118:$P$126</c:f>
                <c:numCache>
                  <c:formatCode>General</c:formatCode>
                  <c:ptCount val="9"/>
                  <c:pt idx="0">
                    <c:v>3.1819805153394595E-4</c:v>
                  </c:pt>
                  <c:pt idx="1">
                    <c:v>6.9685373285934297E-3</c:v>
                  </c:pt>
                  <c:pt idx="2">
                    <c:v>2.1542008088848142E-2</c:v>
                  </c:pt>
                  <c:pt idx="3">
                    <c:v>8.1140503141156027E-3</c:v>
                  </c:pt>
                  <c:pt idx="4">
                    <c:v>6.5230600564458504E-3</c:v>
                  </c:pt>
                  <c:pt idx="5">
                    <c:v>1.8932784066269734E-2</c:v>
                  </c:pt>
                  <c:pt idx="6">
                    <c:v>0.12282444789210328</c:v>
                  </c:pt>
                  <c:pt idx="7">
                    <c:v>0.16864496731299158</c:v>
                  </c:pt>
                  <c:pt idx="8">
                    <c:v>0</c:v>
                  </c:pt>
                </c:numCache>
              </c:numRef>
            </c:minus>
          </c:errBars>
          <c:xVal>
            <c:numRef>
              <c:f>'287PTSmABC'!$K$118:$K$126</c:f>
              <c:numCache>
                <c:formatCode>General</c:formatCode>
                <c:ptCount val="9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</c:numCache>
            </c:numRef>
          </c:xVal>
          <c:yVal>
            <c:numRef>
              <c:f>'287PTSmABC'!$O$118:$O$126</c:f>
              <c:numCache>
                <c:formatCode>General</c:formatCode>
                <c:ptCount val="9"/>
                <c:pt idx="0">
                  <c:v>4.2674999999999998E-2</c:v>
                </c:pt>
                <c:pt idx="1">
                  <c:v>6.8242499999999998E-2</c:v>
                </c:pt>
                <c:pt idx="2">
                  <c:v>0.12665249999999997</c:v>
                </c:pt>
                <c:pt idx="3">
                  <c:v>0.26763749999999997</c:v>
                </c:pt>
                <c:pt idx="4">
                  <c:v>0.50816249999999985</c:v>
                </c:pt>
                <c:pt idx="5">
                  <c:v>0.78626249999999986</c:v>
                </c:pt>
                <c:pt idx="6">
                  <c:v>1.2465000000000002</c:v>
                </c:pt>
                <c:pt idx="7">
                  <c:v>1.1907000000000001</c:v>
                </c:pt>
                <c:pt idx="8">
                  <c:v>1.0984500000000001</c:v>
                </c:pt>
              </c:numCache>
            </c:numRef>
          </c:yVal>
          <c:smooth val="1"/>
        </c:ser>
        <c:axId val="46691456"/>
        <c:axId val="46693376"/>
      </c:scatterChart>
      <c:scatterChart>
        <c:scatterStyle val="smoothMarker"/>
        <c:ser>
          <c:idx val="1"/>
          <c:order val="1"/>
          <c:tx>
            <c:strRef>
              <c:f>'287PTSmABC'!$S$117</c:f>
              <c:strCache>
                <c:ptCount val="1"/>
                <c:pt idx="0">
                  <c:v>glucosa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'287PTSmABC'!$U$118:$U$124</c:f>
                <c:numCache>
                  <c:formatCode>General</c:formatCode>
                  <c:ptCount val="7"/>
                  <c:pt idx="0">
                    <c:v>0.14142135623730973</c:v>
                  </c:pt>
                  <c:pt idx="1">
                    <c:v>0.11313708498984767</c:v>
                  </c:pt>
                  <c:pt idx="2">
                    <c:v>0.14849242404917501</c:v>
                  </c:pt>
                  <c:pt idx="3">
                    <c:v>5.6568542494923699E-2</c:v>
                  </c:pt>
                  <c:pt idx="4">
                    <c:v>1.2020815280171303E-2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'287PTSmABC'!$U$118:$U$124</c:f>
                <c:numCache>
                  <c:formatCode>General</c:formatCode>
                  <c:ptCount val="7"/>
                  <c:pt idx="0">
                    <c:v>0.14142135623730973</c:v>
                  </c:pt>
                  <c:pt idx="1">
                    <c:v>0.11313708498984767</c:v>
                  </c:pt>
                  <c:pt idx="2">
                    <c:v>0.14849242404917501</c:v>
                  </c:pt>
                  <c:pt idx="3">
                    <c:v>5.6568542494923699E-2</c:v>
                  </c:pt>
                  <c:pt idx="4">
                    <c:v>1.2020815280171303E-2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'287PTSmABC'!$Q$118:$Q$124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4</c:v>
                </c:pt>
                <c:pt idx="4">
                  <c:v>18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'287PTSmABC'!$T$118:$T$124</c:f>
              <c:numCache>
                <c:formatCode>General</c:formatCode>
                <c:ptCount val="7"/>
                <c:pt idx="0">
                  <c:v>2.6840000000000002</c:v>
                </c:pt>
                <c:pt idx="1">
                  <c:v>2.5230000000000001</c:v>
                </c:pt>
                <c:pt idx="2">
                  <c:v>2.323</c:v>
                </c:pt>
                <c:pt idx="3">
                  <c:v>1.173</c:v>
                </c:pt>
                <c:pt idx="4">
                  <c:v>0.14800000000000005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1"/>
        </c:ser>
        <c:axId val="46717952"/>
        <c:axId val="46716032"/>
      </c:scatterChart>
      <c:valAx>
        <c:axId val="46691456"/>
        <c:scaling>
          <c:orientation val="minMax"/>
          <c:max val="24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Time (h)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6693376"/>
        <c:crosses val="autoZero"/>
        <c:crossBetween val="midCat"/>
        <c:majorUnit val="4"/>
      </c:valAx>
      <c:valAx>
        <c:axId val="46693376"/>
        <c:scaling>
          <c:orientation val="minMax"/>
        </c:scaling>
        <c:axPos val="l"/>
        <c:majorGridlines>
          <c:spPr>
            <a:ln w="0"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Biomass</a:t>
                </a:r>
                <a:endParaRPr lang="es-MX" sz="700" dirty="0" smtClean="0">
                  <a:effectLst/>
                </a:endParaRPr>
              </a:p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6691456"/>
        <c:crosses val="autoZero"/>
        <c:crossBetween val="midCat"/>
      </c:valAx>
      <c:valAx>
        <c:axId val="46716032"/>
        <c:scaling>
          <c:orientation val="minMax"/>
          <c:min val="0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86526144279641692"/>
              <c:y val="0.15398355209209569"/>
            </c:manualLayout>
          </c:layout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6717952"/>
        <c:crosses val="max"/>
        <c:crossBetween val="midCat"/>
      </c:valAx>
      <c:valAx>
        <c:axId val="46717952"/>
        <c:scaling>
          <c:orientation val="minMax"/>
        </c:scaling>
        <c:delete val="1"/>
        <c:axPos val="b"/>
        <c:numFmt formatCode="General" sourceLinked="1"/>
        <c:tickLblPos val="none"/>
        <c:crossAx val="46716032"/>
        <c:crosses val="autoZero"/>
        <c:crossBetween val="midCat"/>
      </c:valAx>
    </c:plotArea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autoTitleDeleted val="1"/>
    <c:plotArea>
      <c:layout/>
      <c:scatterChart>
        <c:scatterStyle val="smoothMarker"/>
        <c:ser>
          <c:idx val="0"/>
          <c:order val="0"/>
          <c:tx>
            <c:v>Biomasa</c:v>
          </c:tx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plus>
              <c:numRef>
                <c:f>ptsG!$P$96:$P$102</c:f>
                <c:numCache>
                  <c:formatCode>General</c:formatCode>
                  <c:ptCount val="7"/>
                  <c:pt idx="0">
                    <c:v>5.9415906961014938E-4</c:v>
                  </c:pt>
                  <c:pt idx="1">
                    <c:v>1.9801704472090236E-3</c:v>
                  </c:pt>
                  <c:pt idx="2">
                    <c:v>3.3482298308210541E-2</c:v>
                  </c:pt>
                  <c:pt idx="3">
                    <c:v>5.7951806486079484E-2</c:v>
                  </c:pt>
                  <c:pt idx="4">
                    <c:v>2.8192419193819847E-3</c:v>
                  </c:pt>
                  <c:pt idx="5">
                    <c:v>0.1048043623853511</c:v>
                  </c:pt>
                  <c:pt idx="6">
                    <c:v>0</c:v>
                  </c:pt>
                </c:numCache>
              </c:numRef>
            </c:plus>
            <c:minus>
              <c:numRef>
                <c:f>ptsG!$P$96:$P$102</c:f>
                <c:numCache>
                  <c:formatCode>General</c:formatCode>
                  <c:ptCount val="7"/>
                  <c:pt idx="0">
                    <c:v>5.9415906961014938E-4</c:v>
                  </c:pt>
                  <c:pt idx="1">
                    <c:v>1.9801704472090236E-3</c:v>
                  </c:pt>
                  <c:pt idx="2">
                    <c:v>3.3482298308210541E-2</c:v>
                  </c:pt>
                  <c:pt idx="3">
                    <c:v>5.7951806486079484E-2</c:v>
                  </c:pt>
                  <c:pt idx="4">
                    <c:v>2.8192419193819847E-3</c:v>
                  </c:pt>
                  <c:pt idx="5">
                    <c:v>0.1048043623853511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ptsG!$K$96:$K$102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</c:numCache>
            </c:numRef>
          </c:xVal>
          <c:yVal>
            <c:numRef>
              <c:f>ptsG!$O$96:$O$102</c:f>
              <c:numCache>
                <c:formatCode>General</c:formatCode>
                <c:ptCount val="7"/>
                <c:pt idx="0">
                  <c:v>4.3395000000000003E-2</c:v>
                </c:pt>
                <c:pt idx="1">
                  <c:v>0.12013499999999999</c:v>
                </c:pt>
                <c:pt idx="2">
                  <c:v>0.37224000000000007</c:v>
                </c:pt>
                <c:pt idx="3">
                  <c:v>0.87255000000000005</c:v>
                </c:pt>
                <c:pt idx="4">
                  <c:v>1.2665249999999995</c:v>
                </c:pt>
                <c:pt idx="5">
                  <c:v>1.168425</c:v>
                </c:pt>
                <c:pt idx="6">
                  <c:v>1.0977749999999995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ptsG!$V$95</c:f>
              <c:strCache>
                <c:ptCount val="1"/>
                <c:pt idx="0">
                  <c:v>Acetato</c:v>
                </c:pt>
              </c:strCache>
            </c:strRef>
          </c:tx>
          <c:spPr>
            <a:ln w="12700"/>
          </c:spPr>
          <c:marker>
            <c:symbol val="triangle"/>
            <c:size val="3"/>
          </c:marker>
          <c:errBars>
            <c:errDir val="y"/>
            <c:errBarType val="both"/>
            <c:errValType val="cust"/>
            <c:plus>
              <c:numRef>
                <c:f>ptsG!$W$96:$W$102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3.7476659402887032E-2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ptsG!$W$96:$W$102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3.7476659402887032E-2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ptsG!$R$96:$R$102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</c:numCache>
            </c:numRef>
          </c:xVal>
          <c:yVal>
            <c:numRef>
              <c:f>ptsG!$V$96:$V$102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5.9500000000000018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1"/>
        </c:ser>
        <c:axId val="40913536"/>
        <c:axId val="40923904"/>
      </c:scatterChart>
      <c:scatterChart>
        <c:scatterStyle val="smoothMarker"/>
        <c:ser>
          <c:idx val="1"/>
          <c:order val="1"/>
          <c:tx>
            <c:strRef>
              <c:f>ptsG!$AC$95</c:f>
              <c:strCache>
                <c:ptCount val="1"/>
                <c:pt idx="0">
                  <c:v>Glucosa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ptsG!$AD$96:$AD$102</c:f>
                <c:numCache>
                  <c:formatCode>General</c:formatCode>
                  <c:ptCount val="7"/>
                  <c:pt idx="0">
                    <c:v>5.8689862838483577E-2</c:v>
                  </c:pt>
                  <c:pt idx="1">
                    <c:v>6.4346717087975985E-2</c:v>
                  </c:pt>
                  <c:pt idx="2">
                    <c:v>6.4346717087975833E-2</c:v>
                  </c:pt>
                  <c:pt idx="3">
                    <c:v>0.13081475451951163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ptsG!$AD$96:$AD$102</c:f>
                <c:numCache>
                  <c:formatCode>General</c:formatCode>
                  <c:ptCount val="7"/>
                  <c:pt idx="0">
                    <c:v>5.8689862838483577E-2</c:v>
                  </c:pt>
                  <c:pt idx="1">
                    <c:v>6.4346717087975985E-2</c:v>
                  </c:pt>
                  <c:pt idx="2">
                    <c:v>6.4346717087975833E-2</c:v>
                  </c:pt>
                  <c:pt idx="3">
                    <c:v>0.13081475451951163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ptsG!$Y$96:$Y$102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</c:numCache>
            </c:numRef>
          </c:xVal>
          <c:yVal>
            <c:numRef>
              <c:f>ptsG!$AC$96:$AC$102</c:f>
              <c:numCache>
                <c:formatCode>General</c:formatCode>
                <c:ptCount val="7"/>
                <c:pt idx="0">
                  <c:v>2.4564999999999992</c:v>
                </c:pt>
                <c:pt idx="1">
                  <c:v>2.4485000000000001</c:v>
                </c:pt>
                <c:pt idx="2">
                  <c:v>1.8805000000000001</c:v>
                </c:pt>
                <c:pt idx="3">
                  <c:v>0.77250000000000019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1"/>
        </c:ser>
        <c:axId val="40928000"/>
        <c:axId val="40925824"/>
      </c:scatterChart>
      <c:valAx>
        <c:axId val="40913536"/>
        <c:scaling>
          <c:orientation val="minMax"/>
          <c:max val="12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baseline="0" dirty="0">
                    <a:effectLst/>
                  </a:rPr>
                  <a:t>Time (h)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0923904"/>
        <c:crosses val="autoZero"/>
        <c:crossBetween val="midCat"/>
        <c:majorUnit val="2"/>
      </c:valAx>
      <c:valAx>
        <c:axId val="40923904"/>
        <c:scaling>
          <c:orientation val="minMax"/>
          <c:min val="0"/>
        </c:scaling>
        <c:axPos val="l"/>
        <c:majorGridlines>
          <c:spPr>
            <a:ln w="0"/>
          </c:spPr>
        </c:majorGridlines>
        <c:title>
          <c:tx>
            <c:rich>
              <a:bodyPr rot="-5400000" vert="horz"/>
              <a:lstStyle/>
              <a:p>
                <a:pPr>
                  <a:defRPr sz="700"/>
                </a:pPr>
                <a:r>
                  <a:rPr lang="en-US" sz="700" b="1" i="0" baseline="0" dirty="0">
                    <a:effectLst/>
                  </a:rPr>
                  <a:t>Biomass, Acetate</a:t>
                </a:r>
                <a:endParaRPr lang="es-MX" sz="700" dirty="0">
                  <a:effectLst/>
                </a:endParaRPr>
              </a:p>
              <a:p>
                <a:pPr>
                  <a:defRPr sz="700"/>
                </a:pPr>
                <a:r>
                  <a:rPr lang="en-US" sz="700" b="1" i="0" baseline="0" dirty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0913536"/>
        <c:crosses val="autoZero"/>
        <c:crossBetween val="midCat"/>
      </c:valAx>
      <c:valAx>
        <c:axId val="40925824"/>
        <c:scaling>
          <c:orientation val="minMax"/>
          <c:min val="0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0928000"/>
        <c:crosses val="max"/>
        <c:crossBetween val="midCat"/>
      </c:valAx>
      <c:valAx>
        <c:axId val="40928000"/>
        <c:scaling>
          <c:orientation val="minMax"/>
        </c:scaling>
        <c:delete val="1"/>
        <c:axPos val="b"/>
        <c:numFmt formatCode="General" sourceLinked="1"/>
        <c:tickLblPos val="none"/>
        <c:crossAx val="40925824"/>
        <c:crosses val="autoZero"/>
        <c:crossBetween val="midCat"/>
      </c:valAx>
    </c:plotArea>
    <c:plotVisOnly val="1"/>
    <c:dispBlanksAs val="gap"/>
  </c:chart>
  <c:spPr>
    <a:ln>
      <a:noFill/>
    </a:ln>
  </c:sp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scatterChart>
        <c:scatterStyle val="smoothMarker"/>
        <c:ser>
          <c:idx val="0"/>
          <c:order val="0"/>
          <c:tx>
            <c:strRef>
              <c:f>'237ptsGmalX'!$O$112</c:f>
              <c:strCache>
                <c:ptCount val="1"/>
                <c:pt idx="0">
                  <c:v>biomasa</c:v>
                </c:pt>
              </c:strCache>
            </c:strRef>
          </c:tx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plus>
              <c:numRef>
                <c:f>'237ptsGmalX'!$P$113:$P$119</c:f>
                <c:numCache>
                  <c:formatCode>General</c:formatCode>
                  <c:ptCount val="7"/>
                  <c:pt idx="0">
                    <c:v>5.7593847327644309E-3</c:v>
                  </c:pt>
                  <c:pt idx="1">
                    <c:v>3.1597066517320922E-2</c:v>
                  </c:pt>
                  <c:pt idx="2">
                    <c:v>9.1513759621162913E-2</c:v>
                  </c:pt>
                  <c:pt idx="3">
                    <c:v>6.558415395505228E-2</c:v>
                  </c:pt>
                  <c:pt idx="4">
                    <c:v>4.2072853480599554E-2</c:v>
                  </c:pt>
                  <c:pt idx="5">
                    <c:v>7.1735982951375385E-2</c:v>
                  </c:pt>
                  <c:pt idx="6">
                    <c:v>3.9597979746446695E-2</c:v>
                  </c:pt>
                </c:numCache>
              </c:numRef>
            </c:plus>
            <c:minus>
              <c:numRef>
                <c:f>'237ptsGmalX'!$P$113:$P$119</c:f>
                <c:numCache>
                  <c:formatCode>General</c:formatCode>
                  <c:ptCount val="7"/>
                  <c:pt idx="0">
                    <c:v>5.7593847327644309E-3</c:v>
                  </c:pt>
                  <c:pt idx="1">
                    <c:v>3.1597066517320922E-2</c:v>
                  </c:pt>
                  <c:pt idx="2">
                    <c:v>9.1513759621162913E-2</c:v>
                  </c:pt>
                  <c:pt idx="3">
                    <c:v>6.558415395505228E-2</c:v>
                  </c:pt>
                  <c:pt idx="4">
                    <c:v>4.2072853480599554E-2</c:v>
                  </c:pt>
                  <c:pt idx="5">
                    <c:v>7.1735982951375385E-2</c:v>
                  </c:pt>
                  <c:pt idx="6">
                    <c:v>3.9597979746446695E-2</c:v>
                  </c:pt>
                </c:numCache>
              </c:numRef>
            </c:minus>
          </c:errBars>
          <c:xVal>
            <c:numRef>
              <c:f>'237ptsGmalX'!$K$113:$K$119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8</c:v>
                </c:pt>
                <c:pt idx="6">
                  <c:v>22</c:v>
                </c:pt>
              </c:numCache>
            </c:numRef>
          </c:xVal>
          <c:yVal>
            <c:numRef>
              <c:f>'237ptsGmalX'!$O$113:$O$119</c:f>
              <c:numCache>
                <c:formatCode>General</c:formatCode>
                <c:ptCount val="7"/>
                <c:pt idx="0">
                  <c:v>4.2457500000000016E-2</c:v>
                </c:pt>
                <c:pt idx="1">
                  <c:v>0.10100250000000002</c:v>
                </c:pt>
                <c:pt idx="2">
                  <c:v>0.37296000000000012</c:v>
                </c:pt>
                <c:pt idx="3">
                  <c:v>0.63362500000000055</c:v>
                </c:pt>
                <c:pt idx="4">
                  <c:v>0.97025000000000028</c:v>
                </c:pt>
                <c:pt idx="5">
                  <c:v>1.049275</c:v>
                </c:pt>
                <c:pt idx="6">
                  <c:v>0.89200000000000002</c:v>
                </c:pt>
              </c:numCache>
            </c:numRef>
          </c:yVal>
          <c:smooth val="1"/>
        </c:ser>
        <c:axId val="40983552"/>
        <c:axId val="40993920"/>
      </c:scatterChart>
      <c:scatterChart>
        <c:scatterStyle val="smoothMarker"/>
        <c:ser>
          <c:idx val="1"/>
          <c:order val="1"/>
          <c:tx>
            <c:strRef>
              <c:f>'237ptsGmalX'!$T$112</c:f>
              <c:strCache>
                <c:ptCount val="1"/>
                <c:pt idx="0">
                  <c:v>glucosa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'237ptsGmalX'!$U$113:$U$119</c:f>
                <c:numCache>
                  <c:formatCode>General</c:formatCode>
                  <c:ptCount val="7"/>
                  <c:pt idx="0">
                    <c:v>3.6062445840513734E-2</c:v>
                  </c:pt>
                  <c:pt idx="1">
                    <c:v>0.11808683245815364</c:v>
                  </c:pt>
                  <c:pt idx="2">
                    <c:v>0.15485638507985403</c:v>
                  </c:pt>
                  <c:pt idx="3">
                    <c:v>8.4852813742385971E-2</c:v>
                  </c:pt>
                  <c:pt idx="4">
                    <c:v>7.0710678118654832E-3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'237ptsGmalX'!$U$113:$U$119</c:f>
                <c:numCache>
                  <c:formatCode>General</c:formatCode>
                  <c:ptCount val="7"/>
                  <c:pt idx="0">
                    <c:v>3.6062445840513734E-2</c:v>
                  </c:pt>
                  <c:pt idx="1">
                    <c:v>0.11808683245815364</c:v>
                  </c:pt>
                  <c:pt idx="2">
                    <c:v>0.15485638507985403</c:v>
                  </c:pt>
                  <c:pt idx="3">
                    <c:v>8.4852813742385971E-2</c:v>
                  </c:pt>
                  <c:pt idx="4">
                    <c:v>7.0710678118654832E-3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'237ptsGmalX'!$Q$113:$Q$119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5</c:v>
                </c:pt>
                <c:pt idx="5">
                  <c:v>18</c:v>
                </c:pt>
                <c:pt idx="6">
                  <c:v>22</c:v>
                </c:pt>
              </c:numCache>
            </c:numRef>
          </c:xVal>
          <c:yVal>
            <c:numRef>
              <c:f>'237ptsGmalX'!$T$113:$T$119</c:f>
              <c:numCache>
                <c:formatCode>General</c:formatCode>
                <c:ptCount val="7"/>
                <c:pt idx="0">
                  <c:v>2.7744999999999997</c:v>
                </c:pt>
                <c:pt idx="1">
                  <c:v>2.5164999999999988</c:v>
                </c:pt>
                <c:pt idx="2">
                  <c:v>1.6295000000000002</c:v>
                </c:pt>
                <c:pt idx="3">
                  <c:v>0.46</c:v>
                </c:pt>
                <c:pt idx="4">
                  <c:v>9.5000000000000029E-2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1"/>
        </c:ser>
        <c:axId val="41002112"/>
        <c:axId val="40995840"/>
      </c:scatterChart>
      <c:valAx>
        <c:axId val="4098355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Time (h)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maj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0993920"/>
        <c:crosses val="autoZero"/>
        <c:crossBetween val="midCat"/>
        <c:majorUnit val="4"/>
      </c:valAx>
      <c:valAx>
        <c:axId val="40993920"/>
        <c:scaling>
          <c:orientation val="minMax"/>
        </c:scaling>
        <c:axPos val="l"/>
        <c:majorGridlines>
          <c:spPr>
            <a:ln w="0"/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Biomass</a:t>
                </a:r>
                <a:endParaRPr lang="es-MX" sz="700" dirty="0" smtClean="0">
                  <a:effectLst/>
                </a:endParaRPr>
              </a:p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maj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0983552"/>
        <c:crosses val="autoZero"/>
        <c:crossBetween val="midCat"/>
      </c:valAx>
      <c:valAx>
        <c:axId val="40995840"/>
        <c:scaling>
          <c:orientation val="minMax"/>
          <c:min val="0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1002112"/>
        <c:crosses val="max"/>
        <c:crossBetween val="midCat"/>
      </c:valAx>
      <c:valAx>
        <c:axId val="41002112"/>
        <c:scaling>
          <c:orientation val="minMax"/>
        </c:scaling>
        <c:delete val="1"/>
        <c:axPos val="b"/>
        <c:numFmt formatCode="General" sourceLinked="1"/>
        <c:tickLblPos val="none"/>
        <c:crossAx val="40995840"/>
        <c:crosses val="autoZero"/>
        <c:crossBetween val="midCat"/>
      </c:valAx>
    </c:plotArea>
    <c:plotVisOnly val="1"/>
    <c:dispBlanksAs val="gap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scatterChart>
        <c:scatterStyle val="smoothMarker"/>
        <c:ser>
          <c:idx val="0"/>
          <c:order val="0"/>
          <c:tx>
            <c:strRef>
              <c:f>'241ptsGbglF'!$O$118</c:f>
              <c:strCache>
                <c:ptCount val="1"/>
                <c:pt idx="0">
                  <c:v>biomasa</c:v>
                </c:pt>
              </c:strCache>
            </c:strRef>
          </c:tx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plus>
              <c:numRef>
                <c:f>'241ptsGbglF'!$P$119:$P$125</c:f>
                <c:numCache>
                  <c:formatCode>General</c:formatCode>
                  <c:ptCount val="7"/>
                  <c:pt idx="0">
                    <c:v>9.6917645452208566E-3</c:v>
                  </c:pt>
                  <c:pt idx="1">
                    <c:v>2.3159004188436187E-2</c:v>
                  </c:pt>
                  <c:pt idx="2">
                    <c:v>0.10604515512271163</c:v>
                  </c:pt>
                  <c:pt idx="3">
                    <c:v>0.13963792939241121</c:v>
                  </c:pt>
                  <c:pt idx="4">
                    <c:v>3.5451128331831686E-2</c:v>
                  </c:pt>
                  <c:pt idx="5">
                    <c:v>7.334465087857471E-2</c:v>
                  </c:pt>
                  <c:pt idx="6">
                    <c:v>0</c:v>
                  </c:pt>
                </c:numCache>
              </c:numRef>
            </c:plus>
            <c:minus>
              <c:numRef>
                <c:f>'241ptsGbglF'!$P$119:$P$125</c:f>
                <c:numCache>
                  <c:formatCode>General</c:formatCode>
                  <c:ptCount val="7"/>
                  <c:pt idx="0">
                    <c:v>9.6917645452208566E-3</c:v>
                  </c:pt>
                  <c:pt idx="1">
                    <c:v>2.3159004188436187E-2</c:v>
                  </c:pt>
                  <c:pt idx="2">
                    <c:v>0.10604515512271163</c:v>
                  </c:pt>
                  <c:pt idx="3">
                    <c:v>0.13963792939241121</c:v>
                  </c:pt>
                  <c:pt idx="4">
                    <c:v>3.5451128331831686E-2</c:v>
                  </c:pt>
                  <c:pt idx="5">
                    <c:v>7.334465087857471E-2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'241ptsGbglF'!$K$119:$K$125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</c:numCache>
            </c:numRef>
          </c:xVal>
          <c:yVal>
            <c:numRef>
              <c:f>'241ptsGbglF'!$O$119:$O$125</c:f>
              <c:numCache>
                <c:formatCode>General</c:formatCode>
                <c:ptCount val="7"/>
                <c:pt idx="0">
                  <c:v>4.9110000000000029E-2</c:v>
                </c:pt>
                <c:pt idx="1">
                  <c:v>0.12852</c:v>
                </c:pt>
                <c:pt idx="2">
                  <c:v>0.36538500000000013</c:v>
                </c:pt>
                <c:pt idx="3">
                  <c:v>0.73975500000000038</c:v>
                </c:pt>
                <c:pt idx="4">
                  <c:v>1.0391249999999996</c:v>
                </c:pt>
                <c:pt idx="5">
                  <c:v>0.98336249999999958</c:v>
                </c:pt>
                <c:pt idx="6">
                  <c:v>0.88267499999999999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'241ptsGbglF'!$AA$118</c:f>
              <c:strCache>
                <c:ptCount val="1"/>
                <c:pt idx="0">
                  <c:v>acetato</c:v>
                </c:pt>
              </c:strCache>
            </c:strRef>
          </c:tx>
          <c:spPr>
            <a:ln w="12700"/>
          </c:spPr>
          <c:marker>
            <c:symbol val="triangle"/>
            <c:size val="3"/>
          </c:marker>
          <c:errBars>
            <c:errDir val="y"/>
            <c:errBarType val="both"/>
            <c:errValType val="cust"/>
            <c:plus>
              <c:numRef>
                <c:f>'241ptsGbglF'!$AB$119:$AB$125</c:f>
                <c:numCache>
                  <c:formatCode>General</c:formatCode>
                  <c:ptCount val="7"/>
                  <c:pt idx="0">
                    <c:v>1.4142135623730956E-2</c:v>
                  </c:pt>
                  <c:pt idx="1">
                    <c:v>9.1923881554250939E-3</c:v>
                  </c:pt>
                  <c:pt idx="2">
                    <c:v>5.6568542494923784E-3</c:v>
                  </c:pt>
                  <c:pt idx="3">
                    <c:v>7.0710678118654641E-3</c:v>
                  </c:pt>
                  <c:pt idx="4">
                    <c:v>8.768124086713186E-2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'241ptsGbglF'!$AB$119:$AB$125</c:f>
                <c:numCache>
                  <c:formatCode>General</c:formatCode>
                  <c:ptCount val="7"/>
                  <c:pt idx="0">
                    <c:v>1.4142135623730956E-2</c:v>
                  </c:pt>
                  <c:pt idx="1">
                    <c:v>9.1923881554250939E-3</c:v>
                  </c:pt>
                  <c:pt idx="2">
                    <c:v>5.6568542494923784E-3</c:v>
                  </c:pt>
                  <c:pt idx="3">
                    <c:v>7.0710678118654641E-3</c:v>
                  </c:pt>
                  <c:pt idx="4">
                    <c:v>8.768124086713186E-2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'241ptsGbglF'!$X$119:$X$125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</c:numCache>
            </c:numRef>
          </c:xVal>
          <c:yVal>
            <c:numRef>
              <c:f>'241ptsGbglF'!$AA$119:$AA$125</c:f>
              <c:numCache>
                <c:formatCode>General</c:formatCode>
                <c:ptCount val="7"/>
                <c:pt idx="0">
                  <c:v>1.0000000000000004E-2</c:v>
                </c:pt>
                <c:pt idx="1">
                  <c:v>3.3500000000000002E-2</c:v>
                </c:pt>
                <c:pt idx="2">
                  <c:v>3.2000000000000015E-2</c:v>
                </c:pt>
                <c:pt idx="3">
                  <c:v>0.14100000000000001</c:v>
                </c:pt>
                <c:pt idx="4">
                  <c:v>6.200000000000002E-2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1"/>
        </c:ser>
        <c:axId val="41071744"/>
        <c:axId val="41073664"/>
      </c:scatterChart>
      <c:scatterChart>
        <c:scatterStyle val="smoothMarker"/>
        <c:ser>
          <c:idx val="1"/>
          <c:order val="1"/>
          <c:tx>
            <c:strRef>
              <c:f>'241ptsGbglF'!$U$118</c:f>
              <c:strCache>
                <c:ptCount val="1"/>
                <c:pt idx="0">
                  <c:v>glucosa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'241ptsGbglF'!$V$119:$V$125</c:f>
                <c:numCache>
                  <c:formatCode>General</c:formatCode>
                  <c:ptCount val="7"/>
                  <c:pt idx="0">
                    <c:v>0.14849242404917501</c:v>
                  </c:pt>
                  <c:pt idx="1">
                    <c:v>3.6769552621700521E-2</c:v>
                  </c:pt>
                  <c:pt idx="2">
                    <c:v>1.8384776310850264E-2</c:v>
                  </c:pt>
                  <c:pt idx="3">
                    <c:v>0.1336431816442569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'241ptsGbglF'!$V$119:$V$125</c:f>
                <c:numCache>
                  <c:formatCode>General</c:formatCode>
                  <c:ptCount val="7"/>
                  <c:pt idx="0">
                    <c:v>0.14849242404917501</c:v>
                  </c:pt>
                  <c:pt idx="1">
                    <c:v>3.6769552621700521E-2</c:v>
                  </c:pt>
                  <c:pt idx="2">
                    <c:v>1.8384776310850264E-2</c:v>
                  </c:pt>
                  <c:pt idx="3">
                    <c:v>0.1336431816442569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'241ptsGbglF'!$R$119:$R$125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</c:numCache>
            </c:numRef>
          </c:xVal>
          <c:yVal>
            <c:numRef>
              <c:f>'241ptsGbglF'!$U$119:$U$125</c:f>
              <c:numCache>
                <c:formatCode>General</c:formatCode>
                <c:ptCount val="7"/>
                <c:pt idx="0">
                  <c:v>2.5209999999999999</c:v>
                </c:pt>
                <c:pt idx="1">
                  <c:v>2.3939999999999997</c:v>
                </c:pt>
                <c:pt idx="2">
                  <c:v>1.8210000000000002</c:v>
                </c:pt>
                <c:pt idx="3">
                  <c:v>0.78849999999999998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1"/>
        </c:ser>
        <c:axId val="41159680"/>
        <c:axId val="41157760"/>
      </c:scatterChart>
      <c:valAx>
        <c:axId val="41071744"/>
        <c:scaling>
          <c:orientation val="minMax"/>
          <c:max val="12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u="none" strike="noStrike" baseline="0" dirty="0" smtClean="0">
                    <a:effectLst/>
                  </a:rPr>
                  <a:t>Time (h)</a:t>
                </a:r>
                <a:endParaRPr lang="es-MX" sz="700" dirty="0"/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1073664"/>
        <c:crosses val="autoZero"/>
        <c:crossBetween val="midCat"/>
        <c:majorUnit val="2"/>
      </c:valAx>
      <c:valAx>
        <c:axId val="41073664"/>
        <c:scaling>
          <c:orientation val="minMax"/>
          <c:min val="0"/>
        </c:scaling>
        <c:axPos val="l"/>
        <c:majorGridlines>
          <c:spPr>
            <a:ln w="0"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Biomass, Acetate</a:t>
                </a:r>
                <a:endParaRPr lang="es-MX" sz="700" dirty="0" smtClean="0">
                  <a:effectLst/>
                </a:endParaRPr>
              </a:p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1071744"/>
        <c:crosses val="autoZero"/>
        <c:crossBetween val="midCat"/>
      </c:valAx>
      <c:valAx>
        <c:axId val="41157760"/>
        <c:scaling>
          <c:orientation val="minMax"/>
          <c:min val="0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1159680"/>
        <c:crosses val="max"/>
        <c:crossBetween val="midCat"/>
      </c:valAx>
      <c:valAx>
        <c:axId val="41159680"/>
        <c:scaling>
          <c:orientation val="minMax"/>
        </c:scaling>
        <c:delete val="1"/>
        <c:axPos val="b"/>
        <c:numFmt formatCode="General" sourceLinked="1"/>
        <c:tickLblPos val="none"/>
        <c:crossAx val="41157760"/>
        <c:crosses val="autoZero"/>
        <c:crossBetween val="midCat"/>
      </c:valAx>
    </c:plotArea>
    <c:plotVisOnly val="1"/>
    <c:dispBlanksAs val="gap"/>
  </c:chart>
  <c:spPr>
    <a:ln>
      <a:noFill/>
    </a:ln>
  </c:sp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scatterChart>
        <c:scatterStyle val="smoothMarker"/>
        <c:ser>
          <c:idx val="0"/>
          <c:order val="0"/>
          <c:tx>
            <c:strRef>
              <c:f>GnagE!$O$108</c:f>
              <c:strCache>
                <c:ptCount val="1"/>
                <c:pt idx="0">
                  <c:v>Biomasa</c:v>
                </c:pt>
              </c:strCache>
            </c:strRef>
          </c:tx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plus>
              <c:numRef>
                <c:f>GnagE!$P$109:$P$115</c:f>
                <c:numCache>
                  <c:formatCode>General</c:formatCode>
                  <c:ptCount val="7"/>
                  <c:pt idx="0">
                    <c:v>3.1552456322765134E-3</c:v>
                  </c:pt>
                  <c:pt idx="1">
                    <c:v>4.4888110898098589E-3</c:v>
                  </c:pt>
                  <c:pt idx="2">
                    <c:v>3.4391346295252694E-2</c:v>
                  </c:pt>
                  <c:pt idx="3">
                    <c:v>3.1652576909313362E-2</c:v>
                  </c:pt>
                  <c:pt idx="4">
                    <c:v>4.4121997064956182E-2</c:v>
                  </c:pt>
                  <c:pt idx="5">
                    <c:v>6.1971197947110888E-2</c:v>
                  </c:pt>
                  <c:pt idx="6">
                    <c:v>1.7978189911668076E-2</c:v>
                  </c:pt>
                </c:numCache>
              </c:numRef>
            </c:plus>
            <c:minus>
              <c:numRef>
                <c:f>GnagE!$P$109:$P$115</c:f>
                <c:numCache>
                  <c:formatCode>General</c:formatCode>
                  <c:ptCount val="7"/>
                  <c:pt idx="0">
                    <c:v>3.1552456322765134E-3</c:v>
                  </c:pt>
                  <c:pt idx="1">
                    <c:v>4.4888110898098589E-3</c:v>
                  </c:pt>
                  <c:pt idx="2">
                    <c:v>3.4391346295252694E-2</c:v>
                  </c:pt>
                  <c:pt idx="3">
                    <c:v>3.1652576909313362E-2</c:v>
                  </c:pt>
                  <c:pt idx="4">
                    <c:v>4.4121997064956182E-2</c:v>
                  </c:pt>
                  <c:pt idx="5">
                    <c:v>6.1971197947110888E-2</c:v>
                  </c:pt>
                  <c:pt idx="6">
                    <c:v>1.7978189911668076E-2</c:v>
                  </c:pt>
                </c:numCache>
              </c:numRef>
            </c:minus>
          </c:errBars>
          <c:xVal>
            <c:numRef>
              <c:f>GnagE!$K$109:$K$115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9</c:v>
                </c:pt>
                <c:pt idx="6">
                  <c:v>11</c:v>
                </c:pt>
              </c:numCache>
            </c:numRef>
          </c:xVal>
          <c:yVal>
            <c:numRef>
              <c:f>GnagE!$O$109:$O$115</c:f>
              <c:numCache>
                <c:formatCode>General</c:formatCode>
                <c:ptCount val="7"/>
                <c:pt idx="0">
                  <c:v>4.8134999999999997E-2</c:v>
                </c:pt>
                <c:pt idx="1">
                  <c:v>0.10824000000000003</c:v>
                </c:pt>
                <c:pt idx="2">
                  <c:v>0.25332000000000016</c:v>
                </c:pt>
                <c:pt idx="3">
                  <c:v>0.56130000000000013</c:v>
                </c:pt>
                <c:pt idx="4">
                  <c:v>0.95610000000000028</c:v>
                </c:pt>
                <c:pt idx="5">
                  <c:v>1.02525</c:v>
                </c:pt>
                <c:pt idx="6">
                  <c:v>0.99753749999999963</c:v>
                </c:pt>
              </c:numCache>
            </c:numRef>
          </c:yVal>
          <c:smooth val="1"/>
        </c:ser>
        <c:axId val="41227776"/>
        <c:axId val="41229696"/>
      </c:scatterChart>
      <c:scatterChart>
        <c:scatterStyle val="smoothMarker"/>
        <c:ser>
          <c:idx val="1"/>
          <c:order val="1"/>
          <c:tx>
            <c:strRef>
              <c:f>GnagE!$V$108</c:f>
              <c:strCache>
                <c:ptCount val="1"/>
                <c:pt idx="0">
                  <c:v>Glucosa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GnagE!$W$109:$W$115</c:f>
                <c:numCache>
                  <c:formatCode>General</c:formatCode>
                  <c:ptCount val="7"/>
                  <c:pt idx="0">
                    <c:v>1.5307950004273299E-2</c:v>
                  </c:pt>
                  <c:pt idx="1">
                    <c:v>1.9218047073866117E-2</c:v>
                  </c:pt>
                  <c:pt idx="2">
                    <c:v>2.2188585654190119E-2</c:v>
                  </c:pt>
                  <c:pt idx="3">
                    <c:v>7.3511903797956427E-2</c:v>
                  </c:pt>
                  <c:pt idx="4">
                    <c:v>0.13569205331681489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GnagE!$W$109:$W$115</c:f>
                <c:numCache>
                  <c:formatCode>General</c:formatCode>
                  <c:ptCount val="7"/>
                  <c:pt idx="0">
                    <c:v>1.5307950004273299E-2</c:v>
                  </c:pt>
                  <c:pt idx="1">
                    <c:v>1.9218047073866117E-2</c:v>
                  </c:pt>
                  <c:pt idx="2">
                    <c:v>2.2188585654190119E-2</c:v>
                  </c:pt>
                  <c:pt idx="3">
                    <c:v>7.3511903797956427E-2</c:v>
                  </c:pt>
                  <c:pt idx="4">
                    <c:v>0.13569205331681489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GnagE!$R$109:$R$115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9</c:v>
                </c:pt>
                <c:pt idx="6">
                  <c:v>11</c:v>
                </c:pt>
              </c:numCache>
            </c:numRef>
          </c:xVal>
          <c:yVal>
            <c:numRef>
              <c:f>GnagE!$V$109:$V$115</c:f>
              <c:numCache>
                <c:formatCode>General</c:formatCode>
                <c:ptCount val="7"/>
                <c:pt idx="0">
                  <c:v>1.8696666666666666</c:v>
                </c:pt>
                <c:pt idx="1">
                  <c:v>1.7546666666666668</c:v>
                </c:pt>
                <c:pt idx="2">
                  <c:v>1.5036666666666663</c:v>
                </c:pt>
                <c:pt idx="3">
                  <c:v>1.006</c:v>
                </c:pt>
                <c:pt idx="4">
                  <c:v>0.13133333333333339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1"/>
        </c:ser>
        <c:axId val="41254272"/>
        <c:axId val="41252352"/>
      </c:scatterChart>
      <c:valAx>
        <c:axId val="41227776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Time (h)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maj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1229696"/>
        <c:crosses val="autoZero"/>
        <c:crossBetween val="midCat"/>
        <c:majorUnit val="2"/>
      </c:valAx>
      <c:valAx>
        <c:axId val="41229696"/>
        <c:scaling>
          <c:orientation val="minMax"/>
        </c:scaling>
        <c:axPos val="l"/>
        <c:majorGridlines>
          <c:spPr>
            <a:ln w="0"/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Biomass</a:t>
                </a:r>
                <a:endParaRPr lang="es-MX" sz="700" dirty="0" smtClean="0">
                  <a:effectLst/>
                </a:endParaRPr>
              </a:p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5.0432848860297023E-2"/>
              <c:y val="0.26075030733621068"/>
            </c:manualLayout>
          </c:layout>
        </c:title>
        <c:numFmt formatCode="General" sourceLinked="1"/>
        <c:maj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1227776"/>
        <c:crosses val="autoZero"/>
        <c:crossBetween val="midCat"/>
      </c:valAx>
      <c:valAx>
        <c:axId val="41252352"/>
        <c:scaling>
          <c:orientation val="minMax"/>
          <c:min val="0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1254272"/>
        <c:crosses val="max"/>
        <c:crossBetween val="midCat"/>
      </c:valAx>
      <c:valAx>
        <c:axId val="41254272"/>
        <c:scaling>
          <c:orientation val="minMax"/>
        </c:scaling>
        <c:delete val="1"/>
        <c:axPos val="b"/>
        <c:numFmt formatCode="General" sourceLinked="1"/>
        <c:tickLblPos val="none"/>
        <c:crossAx val="41252352"/>
        <c:crosses val="autoZero"/>
        <c:crossBetween val="midCat"/>
      </c:valAx>
    </c:plotArea>
    <c:plotVisOnly val="1"/>
    <c:dispBlanksAs val="gap"/>
  </c:chart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scatterChart>
        <c:scatterStyle val="smoothMarker"/>
        <c:ser>
          <c:idx val="0"/>
          <c:order val="0"/>
          <c:tx>
            <c:strRef>
              <c:f>GmanX!$O$108</c:f>
              <c:strCache>
                <c:ptCount val="1"/>
                <c:pt idx="0">
                  <c:v>Biomasa</c:v>
                </c:pt>
              </c:strCache>
            </c:strRef>
          </c:tx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plus>
              <c:numRef>
                <c:f>GmanX!$P$109:$P$115</c:f>
                <c:numCache>
                  <c:formatCode>General</c:formatCode>
                  <c:ptCount val="7"/>
                  <c:pt idx="0">
                    <c:v>3.6908230789351047E-3</c:v>
                  </c:pt>
                  <c:pt idx="1">
                    <c:v>4.36183570873548E-2</c:v>
                  </c:pt>
                  <c:pt idx="2">
                    <c:v>0.2639284961405266</c:v>
                  </c:pt>
                  <c:pt idx="3">
                    <c:v>0.25954292676421348</c:v>
                  </c:pt>
                  <c:pt idx="4">
                    <c:v>7.2399322337988695E-2</c:v>
                  </c:pt>
                  <c:pt idx="5">
                    <c:v>7.4937611551209746E-2</c:v>
                  </c:pt>
                  <c:pt idx="6">
                    <c:v>0.11152247811540059</c:v>
                  </c:pt>
                </c:numCache>
              </c:numRef>
            </c:plus>
            <c:minus>
              <c:numRef>
                <c:f>GmanX!$P$109:$P$115</c:f>
                <c:numCache>
                  <c:formatCode>General</c:formatCode>
                  <c:ptCount val="7"/>
                  <c:pt idx="0">
                    <c:v>3.6908230789351047E-3</c:v>
                  </c:pt>
                  <c:pt idx="1">
                    <c:v>4.36183570873548E-2</c:v>
                  </c:pt>
                  <c:pt idx="2">
                    <c:v>0.2639284961405266</c:v>
                  </c:pt>
                  <c:pt idx="3">
                    <c:v>0.25954292676421348</c:v>
                  </c:pt>
                  <c:pt idx="4">
                    <c:v>7.2399322337988695E-2</c:v>
                  </c:pt>
                  <c:pt idx="5">
                    <c:v>7.4937611551209746E-2</c:v>
                  </c:pt>
                  <c:pt idx="6">
                    <c:v>0.11152247811540059</c:v>
                  </c:pt>
                </c:numCache>
              </c:numRef>
            </c:minus>
          </c:errBars>
          <c:xVal>
            <c:numRef>
              <c:f>GmanX!$K$109:$K$115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</c:numCache>
            </c:numRef>
          </c:xVal>
          <c:yVal>
            <c:numRef>
              <c:f>GmanX!$O$109:$O$114</c:f>
              <c:numCache>
                <c:formatCode>General</c:formatCode>
                <c:ptCount val="6"/>
                <c:pt idx="0">
                  <c:v>4.8420000000000012E-2</c:v>
                </c:pt>
                <c:pt idx="1">
                  <c:v>0.14793000000000006</c:v>
                </c:pt>
                <c:pt idx="2">
                  <c:v>0.53719499999999998</c:v>
                </c:pt>
                <c:pt idx="3">
                  <c:v>1.2053166666666666</c:v>
                </c:pt>
                <c:pt idx="4">
                  <c:v>1.244475</c:v>
                </c:pt>
                <c:pt idx="5">
                  <c:v>1.1856</c:v>
                </c:pt>
              </c:numCache>
            </c:numRef>
          </c:yVal>
          <c:smooth val="1"/>
        </c:ser>
        <c:axId val="41305984"/>
        <c:axId val="41332736"/>
      </c:scatterChart>
      <c:scatterChart>
        <c:scatterStyle val="smoothMarker"/>
        <c:ser>
          <c:idx val="1"/>
          <c:order val="1"/>
          <c:tx>
            <c:strRef>
              <c:f>GmanX!$V$108</c:f>
              <c:strCache>
                <c:ptCount val="1"/>
                <c:pt idx="0">
                  <c:v>Glucosa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GmanX!$W$109:$W$115</c:f>
                <c:numCache>
                  <c:formatCode>General</c:formatCode>
                  <c:ptCount val="7"/>
                  <c:pt idx="0">
                    <c:v>7.1189886922230911E-2</c:v>
                  </c:pt>
                  <c:pt idx="1">
                    <c:v>0.11594107698884538</c:v>
                  </c:pt>
                  <c:pt idx="2">
                    <c:v>0.32982470091449062</c:v>
                  </c:pt>
                  <c:pt idx="3">
                    <c:v>0.34223968209428918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GmanX!$W$109:$W$115</c:f>
                <c:numCache>
                  <c:formatCode>General</c:formatCode>
                  <c:ptCount val="7"/>
                  <c:pt idx="0">
                    <c:v>7.1189886922230911E-2</c:v>
                  </c:pt>
                  <c:pt idx="1">
                    <c:v>0.11594107698884538</c:v>
                  </c:pt>
                  <c:pt idx="2">
                    <c:v>0.32982470091449062</c:v>
                  </c:pt>
                  <c:pt idx="3">
                    <c:v>0.34223968209428918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GmanX!$R$109:$R$114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</c:numCache>
            </c:numRef>
          </c:xVal>
          <c:yVal>
            <c:numRef>
              <c:f>GmanX!$V$109:$V$114</c:f>
              <c:numCache>
                <c:formatCode>General</c:formatCode>
                <c:ptCount val="6"/>
                <c:pt idx="0">
                  <c:v>2.5089999999999999</c:v>
                </c:pt>
                <c:pt idx="1">
                  <c:v>2.3286666666666669</c:v>
                </c:pt>
                <c:pt idx="2">
                  <c:v>1.6286666666666667</c:v>
                </c:pt>
                <c:pt idx="3">
                  <c:v>0.82200000000000029</c:v>
                </c:pt>
                <c:pt idx="4">
                  <c:v>0</c:v>
                </c:pt>
                <c:pt idx="5">
                  <c:v>0</c:v>
                </c:pt>
              </c:numCache>
            </c:numRef>
          </c:yVal>
          <c:smooth val="1"/>
        </c:ser>
        <c:axId val="41336832"/>
        <c:axId val="41334656"/>
      </c:scatterChart>
      <c:valAx>
        <c:axId val="41305984"/>
        <c:scaling>
          <c:orientation val="minMax"/>
          <c:max val="16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Time (h)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1332736"/>
        <c:crosses val="autoZero"/>
        <c:crossBetween val="midCat"/>
        <c:majorUnit val="2"/>
      </c:valAx>
      <c:valAx>
        <c:axId val="41332736"/>
        <c:scaling>
          <c:orientation val="minMax"/>
          <c:min val="0"/>
        </c:scaling>
        <c:axPos val="l"/>
        <c:majorGridlines>
          <c:spPr>
            <a:ln w="0"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Biomass</a:t>
                </a:r>
                <a:endParaRPr lang="es-MX" sz="700" dirty="0" smtClean="0">
                  <a:effectLst/>
                </a:endParaRPr>
              </a:p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1305984"/>
        <c:crosses val="autoZero"/>
        <c:crossBetween val="midCat"/>
      </c:valAx>
      <c:valAx>
        <c:axId val="41334656"/>
        <c:scaling>
          <c:orientation val="minMax"/>
          <c:min val="0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1336832"/>
        <c:crosses val="max"/>
        <c:crossBetween val="midCat"/>
      </c:valAx>
      <c:valAx>
        <c:axId val="41336832"/>
        <c:scaling>
          <c:orientation val="minMax"/>
        </c:scaling>
        <c:delete val="1"/>
        <c:axPos val="b"/>
        <c:numFmt formatCode="General" sourceLinked="1"/>
        <c:tickLblPos val="none"/>
        <c:crossAx val="41334656"/>
        <c:crosses val="autoZero"/>
        <c:crossBetween val="midCat"/>
      </c:valAx>
    </c:plotArea>
    <c:plotVisOnly val="1"/>
    <c:dispBlanksAs val="gap"/>
  </c:chart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scatterChart>
        <c:scatterStyle val="smoothMarker"/>
        <c:ser>
          <c:idx val="0"/>
          <c:order val="0"/>
          <c:tx>
            <c:strRef>
              <c:f>GXmalX!$M$116</c:f>
              <c:strCache>
                <c:ptCount val="1"/>
                <c:pt idx="0">
                  <c:v>Biomasa</c:v>
                </c:pt>
              </c:strCache>
            </c:strRef>
          </c:tx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plus>
              <c:numRef>
                <c:f>GXmalX!$O$117:$O$123</c:f>
                <c:numCache>
                  <c:formatCode>General</c:formatCode>
                  <c:ptCount val="7"/>
                  <c:pt idx="0">
                    <c:v>1.749992857128278E-3</c:v>
                  </c:pt>
                  <c:pt idx="1">
                    <c:v>1.7605124964055276E-2</c:v>
                  </c:pt>
                  <c:pt idx="2">
                    <c:v>2.7317779924437506E-2</c:v>
                  </c:pt>
                  <c:pt idx="3">
                    <c:v>0.13862069650669079</c:v>
                  </c:pt>
                  <c:pt idx="4">
                    <c:v>0.10407127665691444</c:v>
                  </c:pt>
                  <c:pt idx="5">
                    <c:v>0.11746774291268217</c:v>
                  </c:pt>
                  <c:pt idx="6">
                    <c:v>7.7481225548516108E-2</c:v>
                  </c:pt>
                </c:numCache>
              </c:numRef>
            </c:plus>
            <c:minus>
              <c:numRef>
                <c:f>GXmalX!$O$117:$O$123</c:f>
                <c:numCache>
                  <c:formatCode>General</c:formatCode>
                  <c:ptCount val="7"/>
                  <c:pt idx="0">
                    <c:v>1.749992857128278E-3</c:v>
                  </c:pt>
                  <c:pt idx="1">
                    <c:v>1.7605124964055276E-2</c:v>
                  </c:pt>
                  <c:pt idx="2">
                    <c:v>2.7317779924437506E-2</c:v>
                  </c:pt>
                  <c:pt idx="3">
                    <c:v>0.13862069650669079</c:v>
                  </c:pt>
                  <c:pt idx="4">
                    <c:v>0.10407127665691444</c:v>
                  </c:pt>
                  <c:pt idx="5">
                    <c:v>0.11746774291268217</c:v>
                  </c:pt>
                  <c:pt idx="6">
                    <c:v>7.7481225548516108E-2</c:v>
                  </c:pt>
                </c:numCache>
              </c:numRef>
            </c:minus>
          </c:errBars>
          <c:xVal>
            <c:numRef>
              <c:f>GXmalX!$J$117:$J$123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</c:numCache>
            </c:numRef>
          </c:xVal>
          <c:yVal>
            <c:numRef>
              <c:f>GXmalX!$N$117:$N$123</c:f>
              <c:numCache>
                <c:formatCode>General</c:formatCode>
                <c:ptCount val="7"/>
                <c:pt idx="0">
                  <c:v>4.2644999999999995E-2</c:v>
                </c:pt>
                <c:pt idx="1">
                  <c:v>0.10201500000000002</c:v>
                </c:pt>
                <c:pt idx="2">
                  <c:v>0.24714000000000005</c:v>
                </c:pt>
                <c:pt idx="3">
                  <c:v>0.76627499999999993</c:v>
                </c:pt>
                <c:pt idx="4">
                  <c:v>1.2283500000000001</c:v>
                </c:pt>
                <c:pt idx="5">
                  <c:v>1.196925</c:v>
                </c:pt>
                <c:pt idx="6">
                  <c:v>1.1694374999999999</c:v>
                </c:pt>
              </c:numCache>
            </c:numRef>
          </c:yVal>
          <c:smooth val="1"/>
        </c:ser>
        <c:axId val="41412864"/>
        <c:axId val="42205568"/>
      </c:scatterChart>
      <c:scatterChart>
        <c:scatterStyle val="smoothMarker"/>
        <c:ser>
          <c:idx val="1"/>
          <c:order val="1"/>
          <c:tx>
            <c:strRef>
              <c:f>GXmalX!$U$116</c:f>
              <c:strCache>
                <c:ptCount val="1"/>
                <c:pt idx="0">
                  <c:v>Glucosa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GXmalX!$V$117:$V$124</c:f>
                <c:numCache>
                  <c:formatCode>General</c:formatCode>
                  <c:ptCount val="8"/>
                  <c:pt idx="0">
                    <c:v>0.23688077169749375</c:v>
                  </c:pt>
                  <c:pt idx="1">
                    <c:v>6.3673647086791949E-2</c:v>
                  </c:pt>
                  <c:pt idx="2">
                    <c:v>7.6544104933038412E-2</c:v>
                  </c:pt>
                  <c:pt idx="3">
                    <c:v>7.408103670980852E-2</c:v>
                  </c:pt>
                  <c:pt idx="4">
                    <c:v>0.14606961810497537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GXmalX!$V$117:$V$123</c:f>
                <c:numCache>
                  <c:formatCode>General</c:formatCode>
                  <c:ptCount val="7"/>
                  <c:pt idx="0">
                    <c:v>0.23688077169749375</c:v>
                  </c:pt>
                  <c:pt idx="1">
                    <c:v>6.3673647086791949E-2</c:v>
                  </c:pt>
                  <c:pt idx="2">
                    <c:v>7.6544104933038412E-2</c:v>
                  </c:pt>
                  <c:pt idx="3">
                    <c:v>7.408103670980852E-2</c:v>
                  </c:pt>
                  <c:pt idx="4">
                    <c:v>0.14606961810497537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GXmalX!$Q$117:$Q$123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</c:numCache>
            </c:numRef>
          </c:xVal>
          <c:yVal>
            <c:numRef>
              <c:f>GXmalX!$U$117:$U$123</c:f>
              <c:numCache>
                <c:formatCode>General</c:formatCode>
                <c:ptCount val="7"/>
                <c:pt idx="0">
                  <c:v>2.4435000000000002</c:v>
                </c:pt>
                <c:pt idx="1">
                  <c:v>2.3233333333333337</c:v>
                </c:pt>
                <c:pt idx="2">
                  <c:v>1.9550000000000001</c:v>
                </c:pt>
                <c:pt idx="3">
                  <c:v>1.3339999999999994</c:v>
                </c:pt>
                <c:pt idx="4">
                  <c:v>8.4333333333333343E-2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1"/>
        </c:ser>
        <c:axId val="42217856"/>
        <c:axId val="42207488"/>
      </c:scatterChart>
      <c:valAx>
        <c:axId val="41412864"/>
        <c:scaling>
          <c:orientation val="minMax"/>
          <c:max val="18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Time (h)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2205568"/>
        <c:crosses val="autoZero"/>
        <c:crossBetween val="midCat"/>
        <c:majorUnit val="2"/>
      </c:valAx>
      <c:valAx>
        <c:axId val="42205568"/>
        <c:scaling>
          <c:orientation val="minMax"/>
        </c:scaling>
        <c:axPos val="l"/>
        <c:majorGridlines>
          <c:spPr>
            <a:ln w="0"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Biomass</a:t>
                </a:r>
                <a:endParaRPr lang="es-MX" sz="700" dirty="0" smtClean="0">
                  <a:effectLst/>
                </a:endParaRPr>
              </a:p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1412864"/>
        <c:crosses val="autoZero"/>
        <c:crossBetween val="midCat"/>
      </c:valAx>
      <c:valAx>
        <c:axId val="42207488"/>
        <c:scaling>
          <c:orientation val="minMax"/>
          <c:min val="0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2217856"/>
        <c:crosses val="max"/>
        <c:crossBetween val="midCat"/>
      </c:valAx>
      <c:valAx>
        <c:axId val="42217856"/>
        <c:scaling>
          <c:orientation val="minMax"/>
        </c:scaling>
        <c:delete val="1"/>
        <c:axPos val="b"/>
        <c:numFmt formatCode="General" sourceLinked="1"/>
        <c:tickLblPos val="none"/>
        <c:crossAx val="42207488"/>
        <c:crosses val="autoZero"/>
        <c:crossBetween val="midCat"/>
      </c:valAx>
    </c:plotArea>
    <c:plotVisOnly val="1"/>
    <c:dispBlanksAs val="gap"/>
  </c:chart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scatterChart>
        <c:scatterStyle val="smoothMarker"/>
        <c:ser>
          <c:idx val="0"/>
          <c:order val="0"/>
          <c:tx>
            <c:strRef>
              <c:f>GXbglF!$O$115</c:f>
              <c:strCache>
                <c:ptCount val="1"/>
                <c:pt idx="0">
                  <c:v>Promedio</c:v>
                </c:pt>
              </c:strCache>
            </c:strRef>
          </c:tx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plus>
              <c:numRef>
                <c:f>GXbglF!$P$116:$P$122</c:f>
                <c:numCache>
                  <c:formatCode>General</c:formatCode>
                  <c:ptCount val="7"/>
                  <c:pt idx="0">
                    <c:v>6.3662410416194595E-3</c:v>
                  </c:pt>
                  <c:pt idx="1">
                    <c:v>1.7078611623899568E-2</c:v>
                  </c:pt>
                  <c:pt idx="2">
                    <c:v>4.4128896145269637E-2</c:v>
                  </c:pt>
                  <c:pt idx="3">
                    <c:v>0.11917023275550025</c:v>
                  </c:pt>
                  <c:pt idx="4">
                    <c:v>0.10565548968226887</c:v>
                  </c:pt>
                  <c:pt idx="5">
                    <c:v>4.6912544964007305E-2</c:v>
                  </c:pt>
                  <c:pt idx="6">
                    <c:v>3.4252016364004045E-2</c:v>
                  </c:pt>
                </c:numCache>
              </c:numRef>
            </c:plus>
            <c:minus>
              <c:numRef>
                <c:f>GXbglF!$P$116:$P$122</c:f>
                <c:numCache>
                  <c:formatCode>General</c:formatCode>
                  <c:ptCount val="7"/>
                  <c:pt idx="0">
                    <c:v>6.3662410416194595E-3</c:v>
                  </c:pt>
                  <c:pt idx="1">
                    <c:v>1.7078611623899568E-2</c:v>
                  </c:pt>
                  <c:pt idx="2">
                    <c:v>4.4128896145269637E-2</c:v>
                  </c:pt>
                  <c:pt idx="3">
                    <c:v>0.11917023275550025</c:v>
                  </c:pt>
                  <c:pt idx="4">
                    <c:v>0.10565548968226887</c:v>
                  </c:pt>
                  <c:pt idx="5">
                    <c:v>4.6912544964007305E-2</c:v>
                  </c:pt>
                  <c:pt idx="6">
                    <c:v>3.4252016364004045E-2</c:v>
                  </c:pt>
                </c:numCache>
              </c:numRef>
            </c:minus>
          </c:errBars>
          <c:xVal>
            <c:numRef>
              <c:f>GXbglF!$K$116:$K$122</c:f>
              <c:numCache>
                <c:formatCode>General</c:formatCode>
                <c:ptCount val="7"/>
                <c:pt idx="0" formatCode="0.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</c:numCache>
            </c:numRef>
          </c:xVal>
          <c:yVal>
            <c:numRef>
              <c:f>GXbglF!$O$116:$O$122</c:f>
              <c:numCache>
                <c:formatCode>General</c:formatCode>
                <c:ptCount val="7"/>
                <c:pt idx="0">
                  <c:v>4.3035000000000004E-2</c:v>
                </c:pt>
                <c:pt idx="1">
                  <c:v>9.9810000000000024E-2</c:v>
                </c:pt>
                <c:pt idx="2">
                  <c:v>0.21222000000000005</c:v>
                </c:pt>
                <c:pt idx="3">
                  <c:v>0.58124999999999971</c:v>
                </c:pt>
                <c:pt idx="4">
                  <c:v>1.0076999999999996</c:v>
                </c:pt>
                <c:pt idx="5">
                  <c:v>1.0658999999999996</c:v>
                </c:pt>
                <c:pt idx="6">
                  <c:v>1.0196249999999996</c:v>
                </c:pt>
              </c:numCache>
            </c:numRef>
          </c:yVal>
          <c:smooth val="1"/>
        </c:ser>
        <c:axId val="42293888"/>
        <c:axId val="42324736"/>
      </c:scatterChart>
      <c:scatterChart>
        <c:scatterStyle val="smoothMarker"/>
        <c:ser>
          <c:idx val="1"/>
          <c:order val="1"/>
          <c:tx>
            <c:strRef>
              <c:f>GXbglF!$U$115</c:f>
              <c:strCache>
                <c:ptCount val="1"/>
                <c:pt idx="0">
                  <c:v>Glucosa 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GXbglF!$W$116:$W$122</c:f>
                <c:numCache>
                  <c:formatCode>General</c:formatCode>
                  <c:ptCount val="7"/>
                  <c:pt idx="0">
                    <c:v>9.8994949366115245E-3</c:v>
                  </c:pt>
                  <c:pt idx="1">
                    <c:v>7.7781745930521114E-3</c:v>
                  </c:pt>
                  <c:pt idx="2">
                    <c:v>0.19021172413918122</c:v>
                  </c:pt>
                  <c:pt idx="3">
                    <c:v>0.26375082938258282</c:v>
                  </c:pt>
                  <c:pt idx="4">
                    <c:v>0.18950461735799476</c:v>
                  </c:pt>
                  <c:pt idx="5">
                    <c:v>1.1313708498984764E-2</c:v>
                  </c:pt>
                  <c:pt idx="6">
                    <c:v>7.7781745930520256E-3</c:v>
                  </c:pt>
                </c:numCache>
              </c:numRef>
            </c:plus>
            <c:minus>
              <c:numRef>
                <c:f>GXbglF!$W$116:$W$122</c:f>
                <c:numCache>
                  <c:formatCode>General</c:formatCode>
                  <c:ptCount val="7"/>
                  <c:pt idx="0">
                    <c:v>9.8994949366115245E-3</c:v>
                  </c:pt>
                  <c:pt idx="1">
                    <c:v>7.7781745930521114E-3</c:v>
                  </c:pt>
                  <c:pt idx="2">
                    <c:v>0.19021172413918122</c:v>
                  </c:pt>
                  <c:pt idx="3">
                    <c:v>0.26375082938258282</c:v>
                  </c:pt>
                  <c:pt idx="4">
                    <c:v>0.18950461735799476</c:v>
                  </c:pt>
                  <c:pt idx="5">
                    <c:v>1.1313708498984764E-2</c:v>
                  </c:pt>
                  <c:pt idx="6">
                    <c:v>7.7781745930520256E-3</c:v>
                  </c:pt>
                </c:numCache>
              </c:numRef>
            </c:minus>
          </c:errBars>
          <c:xVal>
            <c:numRef>
              <c:f>GXbglF!$R$116:$R$122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</c:numCache>
            </c:numRef>
          </c:xVal>
          <c:yVal>
            <c:numRef>
              <c:f>GXbglF!$V$116:$V$122</c:f>
              <c:numCache>
                <c:formatCode>General</c:formatCode>
                <c:ptCount val="7"/>
                <c:pt idx="0">
                  <c:v>2.2953333333333332</c:v>
                </c:pt>
                <c:pt idx="1">
                  <c:v>2.1933333333333342</c:v>
                </c:pt>
                <c:pt idx="2">
                  <c:v>1.9026666666666667</c:v>
                </c:pt>
                <c:pt idx="3">
                  <c:v>0.86033333333333351</c:v>
                </c:pt>
                <c:pt idx="4">
                  <c:v>0.18500000000000005</c:v>
                </c:pt>
                <c:pt idx="5">
                  <c:v>1.3333333333333338E-2</c:v>
                </c:pt>
                <c:pt idx="6">
                  <c:v>9.0000000000000028E-3</c:v>
                </c:pt>
              </c:numCache>
            </c:numRef>
          </c:yVal>
          <c:smooth val="1"/>
        </c:ser>
        <c:axId val="42402560"/>
        <c:axId val="42326656"/>
      </c:scatterChart>
      <c:valAx>
        <c:axId val="42293888"/>
        <c:scaling>
          <c:orientation val="minMax"/>
          <c:max val="18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Time (h)</a:t>
                </a:r>
                <a:endParaRPr lang="es-MX" sz="700" dirty="0">
                  <a:effectLst/>
                </a:endParaRPr>
              </a:p>
            </c:rich>
          </c:tx>
        </c:title>
        <c:numFmt formatCode="0" sourceLinked="0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2324736"/>
        <c:crosses val="autoZero"/>
        <c:crossBetween val="midCat"/>
        <c:majorUnit val="2"/>
      </c:valAx>
      <c:valAx>
        <c:axId val="42324736"/>
        <c:scaling>
          <c:orientation val="minMax"/>
        </c:scaling>
        <c:axPos val="l"/>
        <c:majorGridlines>
          <c:spPr>
            <a:ln w="0"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Biomass</a:t>
                </a:r>
                <a:endParaRPr lang="es-MX" sz="700" dirty="0" smtClean="0">
                  <a:effectLst/>
                </a:endParaRPr>
              </a:p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2293888"/>
        <c:crosses val="autoZero"/>
        <c:crossBetween val="midCat"/>
      </c:valAx>
      <c:valAx>
        <c:axId val="42326656"/>
        <c:scaling>
          <c:orientation val="minMax"/>
          <c:min val="0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2402560"/>
        <c:crosses val="max"/>
        <c:crossBetween val="midCat"/>
      </c:valAx>
      <c:valAx>
        <c:axId val="42402560"/>
        <c:scaling>
          <c:orientation val="minMax"/>
        </c:scaling>
        <c:delete val="1"/>
        <c:axPos val="b"/>
        <c:numFmt formatCode="General" sourceLinked="1"/>
        <c:tickLblPos val="none"/>
        <c:crossAx val="42326656"/>
        <c:crosses val="autoZero"/>
        <c:crossBetween val="midCat"/>
      </c:valAx>
    </c:plotArea>
    <c:plotVisOnly val="1"/>
    <c:dispBlanksAs val="gap"/>
  </c:chart>
  <c:externalData r:id="rId1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scatterChart>
        <c:scatterStyle val="smoothMarker"/>
        <c:ser>
          <c:idx val="0"/>
          <c:order val="0"/>
          <c:tx>
            <c:strRef>
              <c:f>GXnagE!$O$96</c:f>
              <c:strCache>
                <c:ptCount val="1"/>
                <c:pt idx="0">
                  <c:v>Biomasa</c:v>
                </c:pt>
              </c:strCache>
            </c:strRef>
          </c:tx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plus>
              <c:numRef>
                <c:f>GXnagE!$Q$97:$Q$103</c:f>
                <c:numCache>
                  <c:formatCode>General</c:formatCode>
                  <c:ptCount val="7"/>
                  <c:pt idx="0">
                    <c:v>3.285924527435165E-3</c:v>
                  </c:pt>
                  <c:pt idx="1">
                    <c:v>1.6937364759607741E-2</c:v>
                  </c:pt>
                  <c:pt idx="2">
                    <c:v>5.2511998628884719E-2</c:v>
                  </c:pt>
                  <c:pt idx="3">
                    <c:v>0.15881594889997627</c:v>
                  </c:pt>
                  <c:pt idx="4">
                    <c:v>0.1661471260660263</c:v>
                  </c:pt>
                  <c:pt idx="5">
                    <c:v>0.15195814390811693</c:v>
                  </c:pt>
                  <c:pt idx="6">
                    <c:v>0</c:v>
                  </c:pt>
                </c:numCache>
              </c:numRef>
            </c:plus>
            <c:minus>
              <c:numRef>
                <c:f>GXnagE!$Q$97:$Q$103</c:f>
                <c:numCache>
                  <c:formatCode>General</c:formatCode>
                  <c:ptCount val="7"/>
                  <c:pt idx="0">
                    <c:v>3.285924527435165E-3</c:v>
                  </c:pt>
                  <c:pt idx="1">
                    <c:v>1.6937364759607741E-2</c:v>
                  </c:pt>
                  <c:pt idx="2">
                    <c:v>5.2511998628884719E-2</c:v>
                  </c:pt>
                  <c:pt idx="3">
                    <c:v>0.15881594889997627</c:v>
                  </c:pt>
                  <c:pt idx="4">
                    <c:v>0.1661471260660263</c:v>
                  </c:pt>
                  <c:pt idx="5">
                    <c:v>0.15195814390811693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GXnagE!$L$97:$L$103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</c:numCache>
            </c:numRef>
          </c:xVal>
          <c:yVal>
            <c:numRef>
              <c:f>GXnagE!$P$97:$P$103</c:f>
              <c:numCache>
                <c:formatCode>General</c:formatCode>
                <c:ptCount val="7"/>
                <c:pt idx="0">
                  <c:v>4.4729999999999992E-2</c:v>
                </c:pt>
                <c:pt idx="1">
                  <c:v>0.12031500000000002</c:v>
                </c:pt>
                <c:pt idx="2">
                  <c:v>0.28995000000000015</c:v>
                </c:pt>
                <c:pt idx="3">
                  <c:v>0.74332500000000024</c:v>
                </c:pt>
                <c:pt idx="4">
                  <c:v>1.1682750000000006</c:v>
                </c:pt>
                <c:pt idx="5">
                  <c:v>1.2627000000000002</c:v>
                </c:pt>
                <c:pt idx="6">
                  <c:v>1.2050999999999996</c:v>
                </c:pt>
              </c:numCache>
            </c:numRef>
          </c:yVal>
          <c:smooth val="1"/>
        </c:ser>
        <c:axId val="42454016"/>
        <c:axId val="42460288"/>
      </c:scatterChart>
      <c:scatterChart>
        <c:scatterStyle val="smoothMarker"/>
        <c:ser>
          <c:idx val="1"/>
          <c:order val="1"/>
          <c:tx>
            <c:strRef>
              <c:f>GXnagE!$W$96</c:f>
              <c:strCache>
                <c:ptCount val="1"/>
                <c:pt idx="0">
                  <c:v>Glucosa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plus>
              <c:numRef>
                <c:f>GXnagE!$X$97:$X$103</c:f>
                <c:numCache>
                  <c:formatCode>General</c:formatCode>
                  <c:ptCount val="7"/>
                  <c:pt idx="0">
                    <c:v>6.8767724987816845E-2</c:v>
                  </c:pt>
                  <c:pt idx="1">
                    <c:v>4.7268735262679988E-2</c:v>
                  </c:pt>
                  <c:pt idx="2">
                    <c:v>5.6500737458314104E-2</c:v>
                  </c:pt>
                  <c:pt idx="3">
                    <c:v>0.18417473587149247</c:v>
                  </c:pt>
                  <c:pt idx="4">
                    <c:v>0.15472987214281977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GXnagE!$X$97:$X$103</c:f>
                <c:numCache>
                  <c:formatCode>General</c:formatCode>
                  <c:ptCount val="7"/>
                  <c:pt idx="0">
                    <c:v>6.8767724987816845E-2</c:v>
                  </c:pt>
                  <c:pt idx="1">
                    <c:v>4.7268735262679988E-2</c:v>
                  </c:pt>
                  <c:pt idx="2">
                    <c:v>5.6500737458314104E-2</c:v>
                  </c:pt>
                  <c:pt idx="3">
                    <c:v>0.18417473587149247</c:v>
                  </c:pt>
                  <c:pt idx="4">
                    <c:v>0.15472987214281977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GXnagE!$S$97:$S$103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</c:numCache>
            </c:numRef>
          </c:xVal>
          <c:yVal>
            <c:numRef>
              <c:f>GXnagE!$W$97:$W$103</c:f>
              <c:numCache>
                <c:formatCode>General</c:formatCode>
                <c:ptCount val="7"/>
                <c:pt idx="0">
                  <c:v>2.661</c:v>
                </c:pt>
                <c:pt idx="1">
                  <c:v>2.5173333333333332</c:v>
                </c:pt>
                <c:pt idx="2">
                  <c:v>2.1446666666666672</c:v>
                </c:pt>
                <c:pt idx="3">
                  <c:v>1.4126666666666661</c:v>
                </c:pt>
                <c:pt idx="4">
                  <c:v>8.9333333333333348E-2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1"/>
        </c:ser>
        <c:axId val="42476672"/>
        <c:axId val="42462208"/>
      </c:scatterChart>
      <c:valAx>
        <c:axId val="42454016"/>
        <c:scaling>
          <c:orientation val="minMax"/>
          <c:max val="18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u="none" strike="noStrike" baseline="0" dirty="0" smtClean="0">
                    <a:effectLst/>
                  </a:rPr>
                  <a:t>Time (h)</a:t>
                </a:r>
                <a:endParaRPr lang="es-MX" sz="700" dirty="0"/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2460288"/>
        <c:crosses val="autoZero"/>
        <c:crossBetween val="midCat"/>
        <c:majorUnit val="2"/>
      </c:valAx>
      <c:valAx>
        <c:axId val="42460288"/>
        <c:scaling>
          <c:orientation val="minMax"/>
        </c:scaling>
        <c:axPos val="l"/>
        <c:majorGridlines>
          <c:spPr>
            <a:ln w="0"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Biomass</a:t>
                </a:r>
                <a:endParaRPr lang="es-MX" sz="700" dirty="0" smtClean="0">
                  <a:effectLst/>
                </a:endParaRPr>
              </a:p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 Conc.,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2454016"/>
        <c:crosses val="autoZero"/>
        <c:crossBetween val="midCat"/>
      </c:valAx>
      <c:valAx>
        <c:axId val="42462208"/>
        <c:scaling>
          <c:orientation val="minMax"/>
          <c:min val="0"/>
        </c:scaling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700" b="1" i="0" baseline="0" dirty="0" smtClean="0">
                    <a:effectLst/>
                  </a:rPr>
                  <a:t>Glucose Conc.,  g/L</a:t>
                </a:r>
                <a:endParaRPr lang="es-MX" sz="700" dirty="0">
                  <a:effectLst/>
                </a:endParaRP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2476672"/>
        <c:crosses val="max"/>
        <c:crossBetween val="midCat"/>
      </c:valAx>
      <c:valAx>
        <c:axId val="42476672"/>
        <c:scaling>
          <c:orientation val="minMax"/>
        </c:scaling>
        <c:delete val="1"/>
        <c:axPos val="b"/>
        <c:numFmt formatCode="General" sourceLinked="1"/>
        <c:tickLblPos val="none"/>
        <c:crossAx val="42462208"/>
        <c:crosses val="autoZero"/>
        <c:crossBetween val="midCat"/>
      </c:valAx>
    </c:plotArea>
    <c:plotVisOnly val="1"/>
    <c:dispBlanksAs val="gap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D547C2A4-58C4-4738-BD1B-40FF716FDA89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s-MX" noProof="0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noProof="0" smtClean="0"/>
              <a:t>Haga clic para modificar el estilo de texto del patrón</a:t>
            </a:r>
          </a:p>
          <a:p>
            <a:pPr lvl="1"/>
            <a:r>
              <a:rPr lang="es-ES" noProof="0" smtClean="0"/>
              <a:t>Segundo nivel</a:t>
            </a:r>
          </a:p>
          <a:p>
            <a:pPr lvl="2"/>
            <a:r>
              <a:rPr lang="es-ES" noProof="0" smtClean="0"/>
              <a:t>Tercer nivel</a:t>
            </a:r>
          </a:p>
          <a:p>
            <a:pPr lvl="3"/>
            <a:r>
              <a:rPr lang="es-ES" noProof="0" smtClean="0"/>
              <a:t>Cuarto nivel</a:t>
            </a:r>
          </a:p>
          <a:p>
            <a:pPr lvl="4"/>
            <a:r>
              <a:rPr lang="es-ES" noProof="0" smtClean="0"/>
              <a:t>Quinto nivel</a:t>
            </a:r>
            <a:endParaRPr lang="es-MX" noProof="0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13C3A74B-EACD-44BB-AF42-2AD8B94739DA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1 Marcador de imagen de diapositiva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5362" name="2 Marcador de notas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endParaRPr lang="en-US" smtClean="0"/>
          </a:p>
        </p:txBody>
      </p:sp>
      <p:sp>
        <p:nvSpPr>
          <p:cNvPr id="15363" name="3 Marcador de número de diapositiva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6FCAD5A8-E5A7-4038-A51B-CF23DA646C1A}" type="slidenum">
              <a:rPr lang="es-MX"/>
              <a:pPr fontAlgn="base">
                <a:spcBef>
                  <a:spcPct val="0"/>
                </a:spcBef>
                <a:spcAft>
                  <a:spcPct val="0"/>
                </a:spcAft>
              </a:pPr>
              <a:t>1</a:t>
            </a:fld>
            <a:endParaRPr lang="es-MX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93EADB-FE5C-4C8F-AC90-063BC19697C4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114669-3206-4DC4-B622-ACAA58BAF4B2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1BD720-3958-4DC0-9089-0541D745841E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B32B8B-9601-4681-95DE-9508C983DBBC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D97E25-34D4-4B5A-A3C4-8EB262554813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8BB10B-DD13-400E-8DAC-58B98657EF63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15ABA3-6E83-4F3E-BC60-EF9ACD2CCD2E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4C98E1-BAF5-4370-9E3B-DC47A10411E2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721CA7-0162-44E9-A92A-FC2F5C59524E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5CCDDD-C70F-41AC-8E67-A70FFFA2FB90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00936F-60A4-4FED-BC89-771A17D29E36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36D0CC-EBBD-4ADC-B635-4B0EB1EB47B1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ADB30C-6FDF-4F98-BB0F-1792760EE7C8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8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9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868D53-7201-4A73-9699-99F2E94F4810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F1D0AB-52F9-435F-B40C-449ED9F492E5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4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5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2D43C2-C9AC-4B2E-A26B-1A8DA5B3D3B8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C71D13-C021-41B7-862C-F775BD0FA8B1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3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4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BD161D-D98C-46C7-8969-0776211B1BBF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311799-12F1-466A-8283-43205C616057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32BAA2-346B-4FED-9568-E608FB2E2811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s-MX" noProof="0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4420B4-94D8-4707-BF99-A7912174A4A5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FE4E62-DF4D-4BEC-8C79-F6101391927E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1 Marcador de título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ítulo del patrón</a:t>
            </a:r>
            <a:endParaRPr lang="es-MX" smtClean="0"/>
          </a:p>
        </p:txBody>
      </p:sp>
      <p:sp>
        <p:nvSpPr>
          <p:cNvPr id="1027" name="2 Marcador de texto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 smtClean="0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4F395BD7-4F34-403B-9200-F43CC17B5574}" type="datetimeFigureOut">
              <a:rPr lang="es-MX"/>
              <a:pPr>
                <a:defRPr/>
              </a:pPr>
              <a:t>23/04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CBDB4680-EF37-4495-8F24-3F4ADB3A4965}" type="slidenum">
              <a:rPr lang="es-MX"/>
              <a:pPr>
                <a:defRPr/>
              </a:pPr>
              <a:t>‹#›</a:t>
            </a:fld>
            <a:endParaRPr lang="es-MX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13" Type="http://schemas.openxmlformats.org/officeDocument/2006/relationships/chart" Target="../charts/chart11.xml"/><Relationship Id="rId18" Type="http://schemas.openxmlformats.org/officeDocument/2006/relationships/chart" Target="../charts/chart1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12" Type="http://schemas.openxmlformats.org/officeDocument/2006/relationships/chart" Target="../charts/chart10.xml"/><Relationship Id="rId17" Type="http://schemas.openxmlformats.org/officeDocument/2006/relationships/chart" Target="../charts/chart15.xml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14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11" Type="http://schemas.openxmlformats.org/officeDocument/2006/relationships/chart" Target="../charts/chart9.xml"/><Relationship Id="rId5" Type="http://schemas.openxmlformats.org/officeDocument/2006/relationships/chart" Target="../charts/chart3.xml"/><Relationship Id="rId15" Type="http://schemas.openxmlformats.org/officeDocument/2006/relationships/chart" Target="../charts/chart1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Relationship Id="rId14" Type="http://schemas.openxmlformats.org/officeDocument/2006/relationships/chart" Target="../charts/char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3 Tabla"/>
          <p:cNvGraphicFramePr>
            <a:graphicFrameLocks noGrp="1"/>
          </p:cNvGraphicFramePr>
          <p:nvPr/>
        </p:nvGraphicFramePr>
        <p:xfrm>
          <a:off x="0" y="0"/>
          <a:ext cx="9144000" cy="623728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286000"/>
                <a:gridCol w="2286000"/>
                <a:gridCol w="2286000"/>
                <a:gridCol w="2286000"/>
              </a:tblGrid>
              <a:tr h="1559328"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</a:tr>
              <a:tr h="1559328"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</a:tr>
              <a:tr h="1559328"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</a:tr>
              <a:tr h="1559328"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s-MX" dirty="0"/>
                    </a:p>
                  </a:txBody>
                  <a:tcPr>
                    <a:noFill/>
                  </a:tcPr>
                </a:tc>
              </a:tr>
            </a:tbl>
          </a:graphicData>
        </a:graphic>
      </p:graphicFrame>
      <p:graphicFrame>
        <p:nvGraphicFramePr>
          <p:cNvPr id="5" name="12 Gráfico"/>
          <p:cNvGraphicFramePr>
            <a:graphicFrameLocks/>
          </p:cNvGraphicFramePr>
          <p:nvPr/>
        </p:nvGraphicFramePr>
        <p:xfrm>
          <a:off x="0" y="1"/>
          <a:ext cx="2267744" cy="15567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4365" name="5 CuadroTexto"/>
          <p:cNvSpPr txBox="1">
            <a:spLocks noChangeArrowheads="1"/>
          </p:cNvSpPr>
          <p:nvPr/>
        </p:nvSpPr>
        <p:spPr bwMode="auto">
          <a:xfrm>
            <a:off x="1979613" y="1287463"/>
            <a:ext cx="288925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A</a:t>
            </a:r>
          </a:p>
        </p:txBody>
      </p:sp>
      <p:sp>
        <p:nvSpPr>
          <p:cNvPr id="14366" name="6 CuadroTexto"/>
          <p:cNvSpPr txBox="1">
            <a:spLocks noChangeArrowheads="1"/>
          </p:cNvSpPr>
          <p:nvPr/>
        </p:nvSpPr>
        <p:spPr bwMode="auto">
          <a:xfrm>
            <a:off x="4284663" y="1287463"/>
            <a:ext cx="287337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B</a:t>
            </a:r>
          </a:p>
        </p:txBody>
      </p:sp>
      <p:sp>
        <p:nvSpPr>
          <p:cNvPr id="14367" name="7 CuadroTexto"/>
          <p:cNvSpPr txBox="1">
            <a:spLocks noChangeArrowheads="1"/>
          </p:cNvSpPr>
          <p:nvPr/>
        </p:nvSpPr>
        <p:spPr bwMode="auto">
          <a:xfrm>
            <a:off x="6588125" y="1287463"/>
            <a:ext cx="287338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C</a:t>
            </a:r>
          </a:p>
        </p:txBody>
      </p:sp>
      <p:sp>
        <p:nvSpPr>
          <p:cNvPr id="14368" name="8 CuadroTexto"/>
          <p:cNvSpPr txBox="1">
            <a:spLocks noChangeArrowheads="1"/>
          </p:cNvSpPr>
          <p:nvPr/>
        </p:nvSpPr>
        <p:spPr bwMode="auto">
          <a:xfrm>
            <a:off x="8848725" y="1287463"/>
            <a:ext cx="287338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D</a:t>
            </a:r>
          </a:p>
        </p:txBody>
      </p:sp>
      <p:sp>
        <p:nvSpPr>
          <p:cNvPr id="14369" name="9 CuadroTexto"/>
          <p:cNvSpPr txBox="1">
            <a:spLocks noChangeArrowheads="1"/>
          </p:cNvSpPr>
          <p:nvPr/>
        </p:nvSpPr>
        <p:spPr bwMode="auto">
          <a:xfrm>
            <a:off x="1978025" y="2852738"/>
            <a:ext cx="288925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E</a:t>
            </a:r>
          </a:p>
        </p:txBody>
      </p:sp>
      <p:sp>
        <p:nvSpPr>
          <p:cNvPr id="14370" name="10 CuadroTexto"/>
          <p:cNvSpPr txBox="1">
            <a:spLocks noChangeArrowheads="1"/>
          </p:cNvSpPr>
          <p:nvPr/>
        </p:nvSpPr>
        <p:spPr bwMode="auto">
          <a:xfrm>
            <a:off x="4284663" y="2849563"/>
            <a:ext cx="287337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F</a:t>
            </a:r>
          </a:p>
        </p:txBody>
      </p:sp>
      <p:sp>
        <p:nvSpPr>
          <p:cNvPr id="14371" name="11 CuadroTexto"/>
          <p:cNvSpPr txBox="1">
            <a:spLocks noChangeArrowheads="1"/>
          </p:cNvSpPr>
          <p:nvPr/>
        </p:nvSpPr>
        <p:spPr bwMode="auto">
          <a:xfrm>
            <a:off x="6588125" y="2849563"/>
            <a:ext cx="287338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G</a:t>
            </a:r>
          </a:p>
        </p:txBody>
      </p:sp>
      <p:sp>
        <p:nvSpPr>
          <p:cNvPr id="14372" name="12 CuadroTexto"/>
          <p:cNvSpPr txBox="1">
            <a:spLocks noChangeArrowheads="1"/>
          </p:cNvSpPr>
          <p:nvPr/>
        </p:nvSpPr>
        <p:spPr bwMode="auto">
          <a:xfrm>
            <a:off x="8848725" y="2849563"/>
            <a:ext cx="287338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H</a:t>
            </a:r>
          </a:p>
        </p:txBody>
      </p:sp>
      <p:sp>
        <p:nvSpPr>
          <p:cNvPr id="14373" name="13 CuadroTexto"/>
          <p:cNvSpPr txBox="1">
            <a:spLocks noChangeArrowheads="1"/>
          </p:cNvSpPr>
          <p:nvPr/>
        </p:nvSpPr>
        <p:spPr bwMode="auto">
          <a:xfrm>
            <a:off x="1978025" y="4437063"/>
            <a:ext cx="288925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I</a:t>
            </a:r>
          </a:p>
        </p:txBody>
      </p:sp>
      <p:sp>
        <p:nvSpPr>
          <p:cNvPr id="14374" name="14 CuadroTexto"/>
          <p:cNvSpPr txBox="1">
            <a:spLocks noChangeArrowheads="1"/>
          </p:cNvSpPr>
          <p:nvPr/>
        </p:nvSpPr>
        <p:spPr bwMode="auto">
          <a:xfrm>
            <a:off x="4284663" y="4437063"/>
            <a:ext cx="287337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J</a:t>
            </a:r>
          </a:p>
        </p:txBody>
      </p:sp>
      <p:sp>
        <p:nvSpPr>
          <p:cNvPr id="14375" name="15 CuadroTexto"/>
          <p:cNvSpPr txBox="1">
            <a:spLocks noChangeArrowheads="1"/>
          </p:cNvSpPr>
          <p:nvPr/>
        </p:nvSpPr>
        <p:spPr bwMode="auto">
          <a:xfrm>
            <a:off x="6588125" y="4437063"/>
            <a:ext cx="287338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K</a:t>
            </a:r>
          </a:p>
        </p:txBody>
      </p:sp>
      <p:sp>
        <p:nvSpPr>
          <p:cNvPr id="14376" name="16 CuadroTexto"/>
          <p:cNvSpPr txBox="1">
            <a:spLocks noChangeArrowheads="1"/>
          </p:cNvSpPr>
          <p:nvPr/>
        </p:nvSpPr>
        <p:spPr bwMode="auto">
          <a:xfrm>
            <a:off x="8848725" y="4427538"/>
            <a:ext cx="287338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L</a:t>
            </a:r>
          </a:p>
        </p:txBody>
      </p:sp>
      <p:sp>
        <p:nvSpPr>
          <p:cNvPr id="14377" name="17 CuadroTexto"/>
          <p:cNvSpPr txBox="1">
            <a:spLocks noChangeArrowheads="1"/>
          </p:cNvSpPr>
          <p:nvPr/>
        </p:nvSpPr>
        <p:spPr bwMode="auto">
          <a:xfrm>
            <a:off x="1978025" y="5949950"/>
            <a:ext cx="288925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M</a:t>
            </a:r>
          </a:p>
        </p:txBody>
      </p:sp>
      <p:sp>
        <p:nvSpPr>
          <p:cNvPr id="14378" name="18 CuadroTexto"/>
          <p:cNvSpPr txBox="1">
            <a:spLocks noChangeArrowheads="1"/>
          </p:cNvSpPr>
          <p:nvPr/>
        </p:nvSpPr>
        <p:spPr bwMode="auto">
          <a:xfrm>
            <a:off x="4284663" y="5959475"/>
            <a:ext cx="287337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N</a:t>
            </a:r>
          </a:p>
        </p:txBody>
      </p:sp>
      <p:sp>
        <p:nvSpPr>
          <p:cNvPr id="14379" name="19 CuadroTexto"/>
          <p:cNvSpPr txBox="1">
            <a:spLocks noChangeArrowheads="1"/>
          </p:cNvSpPr>
          <p:nvPr/>
        </p:nvSpPr>
        <p:spPr bwMode="auto">
          <a:xfrm>
            <a:off x="6588125" y="5959475"/>
            <a:ext cx="287338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O</a:t>
            </a:r>
          </a:p>
        </p:txBody>
      </p:sp>
      <p:sp>
        <p:nvSpPr>
          <p:cNvPr id="14380" name="20 CuadroTexto"/>
          <p:cNvSpPr txBox="1">
            <a:spLocks noChangeArrowheads="1"/>
          </p:cNvSpPr>
          <p:nvPr/>
        </p:nvSpPr>
        <p:spPr bwMode="auto">
          <a:xfrm>
            <a:off x="8848725" y="5969000"/>
            <a:ext cx="287338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MX" sz="1000" b="1">
                <a:latin typeface="Calibri" pitchFamily="34" charset="0"/>
              </a:rPr>
              <a:t>P</a:t>
            </a:r>
          </a:p>
        </p:txBody>
      </p:sp>
      <p:graphicFrame>
        <p:nvGraphicFramePr>
          <p:cNvPr id="23" name="9 Gráfico"/>
          <p:cNvGraphicFramePr>
            <a:graphicFrameLocks/>
          </p:cNvGraphicFramePr>
          <p:nvPr/>
        </p:nvGraphicFramePr>
        <p:xfrm>
          <a:off x="2264073" y="-11038"/>
          <a:ext cx="2307927" cy="15450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4" name="5 Gráfico"/>
          <p:cNvGraphicFramePr>
            <a:graphicFrameLocks/>
          </p:cNvGraphicFramePr>
          <p:nvPr/>
        </p:nvGraphicFramePr>
        <p:xfrm>
          <a:off x="4572000" y="0"/>
          <a:ext cx="2304256" cy="15340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6" name="8 Gráfico"/>
          <p:cNvGraphicFramePr>
            <a:graphicFrameLocks/>
          </p:cNvGraphicFramePr>
          <p:nvPr/>
        </p:nvGraphicFramePr>
        <p:xfrm>
          <a:off x="6876256" y="18415"/>
          <a:ext cx="2259806" cy="1515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7" name="1 Gráfico"/>
          <p:cNvGraphicFramePr>
            <a:graphicFrameLocks/>
          </p:cNvGraphicFramePr>
          <p:nvPr/>
        </p:nvGraphicFramePr>
        <p:xfrm>
          <a:off x="0" y="1548506"/>
          <a:ext cx="2266380" cy="15479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8" name="14 Gráfico"/>
          <p:cNvGraphicFramePr>
            <a:graphicFrameLocks/>
          </p:cNvGraphicFramePr>
          <p:nvPr/>
        </p:nvGraphicFramePr>
        <p:xfrm>
          <a:off x="2285720" y="1556792"/>
          <a:ext cx="2286280" cy="15396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9" name="5 Gráfico"/>
          <p:cNvGraphicFramePr>
            <a:graphicFrameLocks/>
          </p:cNvGraphicFramePr>
          <p:nvPr/>
        </p:nvGraphicFramePr>
        <p:xfrm>
          <a:off x="4572001" y="1534031"/>
          <a:ext cx="2304256" cy="1562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30" name="8 Gráfico"/>
          <p:cNvGraphicFramePr>
            <a:graphicFrameLocks/>
          </p:cNvGraphicFramePr>
          <p:nvPr/>
        </p:nvGraphicFramePr>
        <p:xfrm>
          <a:off x="6876256" y="1591161"/>
          <a:ext cx="2259806" cy="1515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31" name="10 Gráfico"/>
          <p:cNvGraphicFramePr>
            <a:graphicFrameLocks/>
          </p:cNvGraphicFramePr>
          <p:nvPr/>
        </p:nvGraphicFramePr>
        <p:xfrm>
          <a:off x="0" y="3099157"/>
          <a:ext cx="2266380" cy="15751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34" name="1 Gráfico"/>
          <p:cNvGraphicFramePr>
            <a:graphicFrameLocks/>
          </p:cNvGraphicFramePr>
          <p:nvPr/>
        </p:nvGraphicFramePr>
        <p:xfrm>
          <a:off x="4565144" y="3123154"/>
          <a:ext cx="2311112" cy="1551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35" name="5 Gráfico"/>
          <p:cNvGraphicFramePr>
            <a:graphicFrameLocks/>
          </p:cNvGraphicFramePr>
          <p:nvPr/>
        </p:nvGraphicFramePr>
        <p:xfrm>
          <a:off x="2267744" y="3140968"/>
          <a:ext cx="2304256" cy="15333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36" name="13 Gráfico"/>
          <p:cNvGraphicFramePr>
            <a:graphicFrameLocks/>
          </p:cNvGraphicFramePr>
          <p:nvPr/>
        </p:nvGraphicFramePr>
        <p:xfrm>
          <a:off x="6876256" y="3140968"/>
          <a:ext cx="2259806" cy="15333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37" name="5 Gráfico"/>
          <p:cNvGraphicFramePr>
            <a:graphicFrameLocks/>
          </p:cNvGraphicFramePr>
          <p:nvPr/>
        </p:nvGraphicFramePr>
        <p:xfrm>
          <a:off x="0" y="4704222"/>
          <a:ext cx="2267744" cy="15113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38" name="11 Gráfico"/>
          <p:cNvGraphicFramePr>
            <a:graphicFrameLocks/>
          </p:cNvGraphicFramePr>
          <p:nvPr/>
        </p:nvGraphicFramePr>
        <p:xfrm>
          <a:off x="2280196" y="4683333"/>
          <a:ext cx="2291804" cy="15322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40" name="7 Gráfico"/>
          <p:cNvGraphicFramePr>
            <a:graphicFrameLocks/>
          </p:cNvGraphicFramePr>
          <p:nvPr/>
        </p:nvGraphicFramePr>
        <p:xfrm>
          <a:off x="4572000" y="4692888"/>
          <a:ext cx="2304256" cy="15026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41" name="5 Gráfico"/>
          <p:cNvGraphicFramePr>
            <a:graphicFrameLocks/>
          </p:cNvGraphicFramePr>
          <p:nvPr/>
        </p:nvGraphicFramePr>
        <p:xfrm>
          <a:off x="6895256" y="4705185"/>
          <a:ext cx="2259806" cy="15121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10</TotalTime>
  <Words>17</Words>
  <Application>Microsoft Office PowerPoint</Application>
  <PresentationFormat>On-screen Show (4:3)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Tema d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afugre</dc:creator>
  <cp:lastModifiedBy>Guillermo Gosset</cp:lastModifiedBy>
  <cp:revision>28</cp:revision>
  <dcterms:created xsi:type="dcterms:W3CDTF">2013-04-20T17:32:19Z</dcterms:created>
  <dcterms:modified xsi:type="dcterms:W3CDTF">2013-04-23T14:47:23Z</dcterms:modified>
</cp:coreProperties>
</file>